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jpeg" ContentType="image/jpeg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modernComment_117_34C5F0E4.xml" ContentType="application/vnd.ms-powerpoint.comments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75" r:id="rId2"/>
    <p:sldId id="270" r:id="rId3"/>
    <p:sldId id="271" r:id="rId4"/>
    <p:sldId id="272" r:id="rId5"/>
    <p:sldId id="273" r:id="rId6"/>
    <p:sldId id="274" r:id="rId7"/>
    <p:sldId id="276" r:id="rId8"/>
    <p:sldId id="278" r:id="rId9"/>
    <p:sldId id="277" r:id="rId10"/>
    <p:sldId id="279" r:id="rId11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396A35B-DC08-809C-A6F2-9C2BFEDCBFC3}" name="Samantha Smith" initials="SS" userId="46674eb2fb326772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E3F6A57-789E-45D1-BCA1-F9DB26406392}" v="393" dt="2022-03-16T02:12:25.58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9" autoAdjust="0"/>
    <p:restoredTop sz="92280" autoAdjust="0"/>
  </p:normalViewPr>
  <p:slideViewPr>
    <p:cSldViewPr snapToGrid="0">
      <p:cViewPr varScale="1">
        <p:scale>
          <a:sx n="71" d="100"/>
          <a:sy n="71" d="100"/>
        </p:scale>
        <p:origin x="2241" y="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18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mantha Smith" userId="46674eb2fb326772" providerId="LiveId" clId="{9E3F6A57-789E-45D1-BCA1-F9DB26406392}"/>
    <pc:docChg chg="undo custSel addSld delSld modSld modMainMaster">
      <pc:chgData name="Samantha Smith" userId="46674eb2fb326772" providerId="LiveId" clId="{9E3F6A57-789E-45D1-BCA1-F9DB26406392}" dt="2022-04-05T16:28:51.984" v="1262" actId="1076"/>
      <pc:docMkLst>
        <pc:docMk/>
      </pc:docMkLst>
      <pc:sldChg chg="addSp delSp modSp del mod">
        <pc:chgData name="Samantha Smith" userId="46674eb2fb326772" providerId="LiveId" clId="{9E3F6A57-789E-45D1-BCA1-F9DB26406392}" dt="2022-03-31T17:58:38.124" v="1052" actId="2696"/>
        <pc:sldMkLst>
          <pc:docMk/>
          <pc:sldMk cId="1883099415" sldId="257"/>
        </pc:sldMkLst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1883099415" sldId="257"/>
            <ac:spMk id="8" creationId="{7B22F8E0-F8D0-4CF6-BD92-4CFE4094CFF1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1883099415" sldId="257"/>
            <ac:spMk id="125" creationId="{F02BF7D9-CCD3-4604-9165-D1943EF0719C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1883099415" sldId="257"/>
            <ac:spMk id="126" creationId="{49A30A4D-B57B-419D-A5B1-FA8E0180EE5B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1883099415" sldId="257"/>
            <ac:spMk id="127" creationId="{63510BD8-E721-4FB5-B694-D82F2EC99FE9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1883099415" sldId="257"/>
            <ac:spMk id="128" creationId="{E51F5592-3C92-4842-AE00-DB845995B6E5}"/>
          </ac:spMkLst>
        </pc:spChg>
        <pc:graphicFrameChg chg="add del mod">
          <ac:chgData name="Samantha Smith" userId="46674eb2fb326772" providerId="LiveId" clId="{9E3F6A57-789E-45D1-BCA1-F9DB26406392}" dt="2022-03-08T23:02:01.931" v="50"/>
          <ac:graphicFrameMkLst>
            <pc:docMk/>
            <pc:sldMk cId="1883099415" sldId="257"/>
            <ac:graphicFrameMk id="2" creationId="{033B057D-6367-46EC-A9EA-14DCDBADA79D}"/>
          </ac:graphicFrameMkLst>
        </pc:graphicFrameChg>
        <pc:graphicFrameChg chg="add del mod">
          <ac:chgData name="Samantha Smith" userId="46674eb2fb326772" providerId="LiveId" clId="{9E3F6A57-789E-45D1-BCA1-F9DB26406392}" dt="2022-03-08T23:02:17.304" v="55" actId="478"/>
          <ac:graphicFrameMkLst>
            <pc:docMk/>
            <pc:sldMk cId="1883099415" sldId="257"/>
            <ac:graphicFrameMk id="3" creationId="{B479403A-CCF4-4335-9C9E-2C040A05D768}"/>
          </ac:graphicFrameMkLst>
        </pc:graphicFrameChg>
        <pc:graphicFrameChg chg="add mod">
          <ac:chgData name="Samantha Smith" userId="46674eb2fb326772" providerId="LiveId" clId="{9E3F6A57-789E-45D1-BCA1-F9DB26406392}" dt="2022-03-16T02:11:27.130" v="590"/>
          <ac:graphicFrameMkLst>
            <pc:docMk/>
            <pc:sldMk cId="1883099415" sldId="257"/>
            <ac:graphicFrameMk id="5" creationId="{E52D4C07-5782-461F-9620-3A96453B3247}"/>
          </ac:graphicFrameMkLst>
        </pc:graphicFrameChg>
        <pc:picChg chg="mod">
          <ac:chgData name="Samantha Smith" userId="46674eb2fb326772" providerId="LiveId" clId="{9E3F6A57-789E-45D1-BCA1-F9DB26406392}" dt="2022-03-16T02:11:27.130" v="590"/>
          <ac:picMkLst>
            <pc:docMk/>
            <pc:sldMk cId="1883099415" sldId="257"/>
            <ac:picMk id="4" creationId="{857A5144-FA8B-4D40-B785-38CE2773CC6E}"/>
          </ac:picMkLst>
        </pc:picChg>
      </pc:sldChg>
      <pc:sldChg chg="del">
        <pc:chgData name="Samantha Smith" userId="46674eb2fb326772" providerId="LiveId" clId="{9E3F6A57-789E-45D1-BCA1-F9DB26406392}" dt="2022-02-06T04:48:58.387" v="1" actId="2696"/>
        <pc:sldMkLst>
          <pc:docMk/>
          <pc:sldMk cId="207899643" sldId="258"/>
        </pc:sldMkLst>
      </pc:sldChg>
      <pc:sldChg chg="addSp delSp modSp del mod">
        <pc:chgData name="Samantha Smith" userId="46674eb2fb326772" providerId="LiveId" clId="{9E3F6A57-789E-45D1-BCA1-F9DB26406392}" dt="2022-03-31T17:58:38.124" v="1052" actId="2696"/>
        <pc:sldMkLst>
          <pc:docMk/>
          <pc:sldMk cId="3110800043" sldId="260"/>
        </pc:sldMkLst>
        <pc:spChg chg="mod">
          <ac:chgData name="Samantha Smith" userId="46674eb2fb326772" providerId="LiveId" clId="{9E3F6A57-789E-45D1-BCA1-F9DB26406392}" dt="2022-03-16T02:14:43.231" v="609" actId="1076"/>
          <ac:spMkLst>
            <pc:docMk/>
            <pc:sldMk cId="3110800043" sldId="260"/>
            <ac:spMk id="8" creationId="{280274B0-51CE-4007-8B2D-1FE10BF66373}"/>
          </ac:spMkLst>
        </pc:spChg>
        <pc:spChg chg="mod">
          <ac:chgData name="Samantha Smith" userId="46674eb2fb326772" providerId="LiveId" clId="{9E3F6A57-789E-45D1-BCA1-F9DB26406392}" dt="2022-03-16T02:14:43.231" v="609" actId="1076"/>
          <ac:spMkLst>
            <pc:docMk/>
            <pc:sldMk cId="3110800043" sldId="260"/>
            <ac:spMk id="39" creationId="{D5640854-3B7A-4D7D-87A4-DF6A9EBB0F24}"/>
          </ac:spMkLst>
        </pc:spChg>
        <pc:spChg chg="del">
          <ac:chgData name="Samantha Smith" userId="46674eb2fb326772" providerId="LiveId" clId="{9E3F6A57-789E-45D1-BCA1-F9DB26406392}" dt="2022-03-11T17:44:01.081" v="216" actId="478"/>
          <ac:spMkLst>
            <pc:docMk/>
            <pc:sldMk cId="3110800043" sldId="260"/>
            <ac:spMk id="63" creationId="{737BC8AC-A231-4393-B590-D89456A38906}"/>
          </ac:spMkLst>
        </pc:spChg>
        <pc:spChg chg="add del mod">
          <ac:chgData name="Samantha Smith" userId="46674eb2fb326772" providerId="LiveId" clId="{9E3F6A57-789E-45D1-BCA1-F9DB26406392}" dt="2022-03-16T02:18:07.242" v="640" actId="21"/>
          <ac:spMkLst>
            <pc:docMk/>
            <pc:sldMk cId="3110800043" sldId="260"/>
            <ac:spMk id="64" creationId="{F71F89E3-084E-4C25-955A-FCED7CABCE1D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3110800043" sldId="260"/>
            <ac:spMk id="75" creationId="{E81F433F-F99F-4B7A-9A2A-F84935059F5D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3110800043" sldId="260"/>
            <ac:spMk id="76" creationId="{5CED7467-54BE-4352-80E2-DF873FA13543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3110800043" sldId="260"/>
            <ac:spMk id="77" creationId="{3B6AB706-CF43-4AC6-8B5D-02122E57DA77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3110800043" sldId="260"/>
            <ac:spMk id="78" creationId="{8E2E28EE-C302-4EA0-B71D-2BF22C383AA0}"/>
          </ac:spMkLst>
        </pc:spChg>
        <pc:spChg chg="add del mod">
          <ac:chgData name="Samantha Smith" userId="46674eb2fb326772" providerId="LiveId" clId="{9E3F6A57-789E-45D1-BCA1-F9DB26406392}" dt="2022-03-16T02:18:07.242" v="640" actId="21"/>
          <ac:spMkLst>
            <pc:docMk/>
            <pc:sldMk cId="3110800043" sldId="260"/>
            <ac:spMk id="81" creationId="{CBBE9398-352A-4813-8E4F-B7E3E283B616}"/>
          </ac:spMkLst>
        </pc:spChg>
        <pc:spChg chg="add del mod">
          <ac:chgData name="Samantha Smith" userId="46674eb2fb326772" providerId="LiveId" clId="{9E3F6A57-789E-45D1-BCA1-F9DB26406392}" dt="2022-03-16T02:18:07.242" v="640" actId="21"/>
          <ac:spMkLst>
            <pc:docMk/>
            <pc:sldMk cId="3110800043" sldId="260"/>
            <ac:spMk id="82" creationId="{6C4C7FD0-A1D6-4C46-922A-DB455331B078}"/>
          </ac:spMkLst>
        </pc:spChg>
        <pc:spChg chg="add del mod">
          <ac:chgData name="Samantha Smith" userId="46674eb2fb326772" providerId="LiveId" clId="{9E3F6A57-789E-45D1-BCA1-F9DB26406392}" dt="2022-03-16T02:18:07.242" v="640" actId="21"/>
          <ac:spMkLst>
            <pc:docMk/>
            <pc:sldMk cId="3110800043" sldId="260"/>
            <ac:spMk id="83" creationId="{A364F056-190A-4B00-839F-A94B49EAD6C2}"/>
          </ac:spMkLst>
        </pc:spChg>
        <pc:spChg chg="add del mod">
          <ac:chgData name="Samantha Smith" userId="46674eb2fb326772" providerId="LiveId" clId="{9E3F6A57-789E-45D1-BCA1-F9DB26406392}" dt="2022-03-16T02:18:07.242" v="640" actId="21"/>
          <ac:spMkLst>
            <pc:docMk/>
            <pc:sldMk cId="3110800043" sldId="260"/>
            <ac:spMk id="84" creationId="{EBCD286E-C10F-4221-873E-8635624AF96F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3110800043" sldId="260"/>
            <ac:spMk id="96" creationId="{C8CA6493-65DC-417A-A910-CC0DBCEB7DE9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3110800043" sldId="260"/>
            <ac:spMk id="97" creationId="{AE0398A9-2DAD-413C-870E-EAAB0CEBE4C5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3110800043" sldId="260"/>
            <ac:spMk id="98" creationId="{F826BB09-BB90-41C8-8D17-9B8F112DD3A1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3110800043" sldId="260"/>
            <ac:spMk id="100" creationId="{5A35C1D8-6286-4DF6-AE13-F4B322F6F4BE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3110800043" sldId="260"/>
            <ac:spMk id="103" creationId="{66BA2124-A578-44C8-A1EA-B95FD7D6F89E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3110800043" sldId="260"/>
            <ac:spMk id="108" creationId="{7691AF0A-4AF1-4A6D-9C89-5A8D21A1FE4D}"/>
          </ac:spMkLst>
        </pc:spChg>
        <pc:spChg chg="add del mod">
          <ac:chgData name="Samantha Smith" userId="46674eb2fb326772" providerId="LiveId" clId="{9E3F6A57-789E-45D1-BCA1-F9DB26406392}" dt="2022-03-16T02:18:07.242" v="640" actId="21"/>
          <ac:spMkLst>
            <pc:docMk/>
            <pc:sldMk cId="3110800043" sldId="260"/>
            <ac:spMk id="112" creationId="{0BCD6EDA-4264-4C8B-BE78-914F71A5F95A}"/>
          </ac:spMkLst>
        </pc:spChg>
        <pc:spChg chg="add del mod">
          <ac:chgData name="Samantha Smith" userId="46674eb2fb326772" providerId="LiveId" clId="{9E3F6A57-789E-45D1-BCA1-F9DB26406392}" dt="2022-03-16T02:18:07.242" v="640" actId="21"/>
          <ac:spMkLst>
            <pc:docMk/>
            <pc:sldMk cId="3110800043" sldId="260"/>
            <ac:spMk id="113" creationId="{8B8D73C8-5BB0-4A6B-8C18-371E55D6712F}"/>
          </ac:spMkLst>
        </pc:spChg>
        <pc:spChg chg="add del mod">
          <ac:chgData name="Samantha Smith" userId="46674eb2fb326772" providerId="LiveId" clId="{9E3F6A57-789E-45D1-BCA1-F9DB26406392}" dt="2022-03-16T02:18:07.242" v="640" actId="21"/>
          <ac:spMkLst>
            <pc:docMk/>
            <pc:sldMk cId="3110800043" sldId="260"/>
            <ac:spMk id="114" creationId="{5CC9052D-6852-4C40-8CA4-266DE8D606CF}"/>
          </ac:spMkLst>
        </pc:spChg>
        <pc:grpChg chg="mod">
          <ac:chgData name="Samantha Smith" userId="46674eb2fb326772" providerId="LiveId" clId="{9E3F6A57-789E-45D1-BCA1-F9DB26406392}" dt="2022-03-16T02:11:27.130" v="590"/>
          <ac:grpSpMkLst>
            <pc:docMk/>
            <pc:sldMk cId="3110800043" sldId="260"/>
            <ac:grpSpMk id="3" creationId="{6673891D-1ED6-4BB7-8858-68D0CB61319C}"/>
          </ac:grpSpMkLst>
        </pc:grpChg>
        <pc:grpChg chg="add del mod">
          <ac:chgData name="Samantha Smith" userId="46674eb2fb326772" providerId="LiveId" clId="{9E3F6A57-789E-45D1-BCA1-F9DB26406392}" dt="2022-03-16T02:18:07.242" v="640" actId="21"/>
          <ac:grpSpMkLst>
            <pc:docMk/>
            <pc:sldMk cId="3110800043" sldId="260"/>
            <ac:grpSpMk id="4" creationId="{ABC7A336-C58B-401C-9336-BF89FEC21426}"/>
          </ac:grpSpMkLst>
        </pc:grpChg>
        <pc:grpChg chg="mod">
          <ac:chgData name="Samantha Smith" userId="46674eb2fb326772" providerId="LiveId" clId="{9E3F6A57-789E-45D1-BCA1-F9DB26406392}" dt="2022-03-16T02:14:43.231" v="609" actId="1076"/>
          <ac:grpSpMkLst>
            <pc:docMk/>
            <pc:sldMk cId="3110800043" sldId="260"/>
            <ac:grpSpMk id="5" creationId="{39E34E6D-CC2C-4924-B9F3-78918AC325F3}"/>
          </ac:grpSpMkLst>
        </pc:grpChg>
        <pc:grpChg chg="mod">
          <ac:chgData name="Samantha Smith" userId="46674eb2fb326772" providerId="LiveId" clId="{9E3F6A57-789E-45D1-BCA1-F9DB26406392}" dt="2022-03-16T02:14:43.231" v="609" actId="1076"/>
          <ac:grpSpMkLst>
            <pc:docMk/>
            <pc:sldMk cId="3110800043" sldId="260"/>
            <ac:grpSpMk id="7" creationId="{594AE80F-E332-4B4E-A6DD-3994DE5FC569}"/>
          </ac:grpSpMkLst>
        </pc:grpChg>
        <pc:grpChg chg="mod">
          <ac:chgData name="Samantha Smith" userId="46674eb2fb326772" providerId="LiveId" clId="{9E3F6A57-789E-45D1-BCA1-F9DB26406392}" dt="2022-03-16T02:14:43.231" v="609" actId="1076"/>
          <ac:grpSpMkLst>
            <pc:docMk/>
            <pc:sldMk cId="3110800043" sldId="260"/>
            <ac:grpSpMk id="9" creationId="{3DC59355-1F96-4F84-83E4-A881A8AF0B57}"/>
          </ac:grpSpMkLst>
        </pc:grpChg>
        <pc:grpChg chg="mod">
          <ac:chgData name="Samantha Smith" userId="46674eb2fb326772" providerId="LiveId" clId="{9E3F6A57-789E-45D1-BCA1-F9DB26406392}" dt="2022-03-16T02:14:43.231" v="609" actId="1076"/>
          <ac:grpSpMkLst>
            <pc:docMk/>
            <pc:sldMk cId="3110800043" sldId="260"/>
            <ac:grpSpMk id="10" creationId="{01156A41-EC3C-4EE3-95DE-A9552F6F28E7}"/>
          </ac:grpSpMkLst>
        </pc:grpChg>
        <pc:grpChg chg="add del mod">
          <ac:chgData name="Samantha Smith" userId="46674eb2fb326772" providerId="LiveId" clId="{9E3F6A57-789E-45D1-BCA1-F9DB26406392}" dt="2022-03-16T02:18:07.242" v="640" actId="21"/>
          <ac:grpSpMkLst>
            <pc:docMk/>
            <pc:sldMk cId="3110800043" sldId="260"/>
            <ac:grpSpMk id="28" creationId="{5C66E942-DE3E-416F-B448-2B7BB3417FD8}"/>
          </ac:grpSpMkLst>
        </pc:grpChg>
        <pc:grpChg chg="mod">
          <ac:chgData name="Samantha Smith" userId="46674eb2fb326772" providerId="LiveId" clId="{9E3F6A57-789E-45D1-BCA1-F9DB26406392}" dt="2022-03-16T02:14:43.231" v="609" actId="1076"/>
          <ac:grpSpMkLst>
            <pc:docMk/>
            <pc:sldMk cId="3110800043" sldId="260"/>
            <ac:grpSpMk id="29" creationId="{033F507F-8ECA-4183-808A-25628D0E8A53}"/>
          </ac:grpSpMkLst>
        </pc:grpChg>
        <pc:grpChg chg="mod">
          <ac:chgData name="Samantha Smith" userId="46674eb2fb326772" providerId="LiveId" clId="{9E3F6A57-789E-45D1-BCA1-F9DB26406392}" dt="2022-03-16T02:14:43.231" v="609" actId="1076"/>
          <ac:grpSpMkLst>
            <pc:docMk/>
            <pc:sldMk cId="3110800043" sldId="260"/>
            <ac:grpSpMk id="36" creationId="{5F3085CC-74D3-4994-B682-6A4B329C07FE}"/>
          </ac:grpSpMkLst>
        </pc:grpChg>
        <pc:grpChg chg="mod">
          <ac:chgData name="Samantha Smith" userId="46674eb2fb326772" providerId="LiveId" clId="{9E3F6A57-789E-45D1-BCA1-F9DB26406392}" dt="2022-03-16T02:14:43.231" v="609" actId="1076"/>
          <ac:grpSpMkLst>
            <pc:docMk/>
            <pc:sldMk cId="3110800043" sldId="260"/>
            <ac:grpSpMk id="38" creationId="{FD468D34-4767-4FB5-97BF-63486254AEF7}"/>
          </ac:grpSpMkLst>
        </pc:grpChg>
        <pc:grpChg chg="mod">
          <ac:chgData name="Samantha Smith" userId="46674eb2fb326772" providerId="LiveId" clId="{9E3F6A57-789E-45D1-BCA1-F9DB26406392}" dt="2022-03-16T02:14:43.231" v="609" actId="1076"/>
          <ac:grpSpMkLst>
            <pc:docMk/>
            <pc:sldMk cId="3110800043" sldId="260"/>
            <ac:grpSpMk id="40" creationId="{7BE4B6D7-D763-43FC-964B-DCF06BB4DF5D}"/>
          </ac:grpSpMkLst>
        </pc:grpChg>
        <pc:grpChg chg="mod">
          <ac:chgData name="Samantha Smith" userId="46674eb2fb326772" providerId="LiveId" clId="{9E3F6A57-789E-45D1-BCA1-F9DB26406392}" dt="2022-03-16T02:14:43.231" v="609" actId="1076"/>
          <ac:grpSpMkLst>
            <pc:docMk/>
            <pc:sldMk cId="3110800043" sldId="260"/>
            <ac:grpSpMk id="41" creationId="{04175A9B-61B9-4DA3-BBEF-978E6F3618E0}"/>
          </ac:grpSpMkLst>
        </pc:grpChg>
        <pc:grpChg chg="add del mod">
          <ac:chgData name="Samantha Smith" userId="46674eb2fb326772" providerId="LiveId" clId="{9E3F6A57-789E-45D1-BCA1-F9DB26406392}" dt="2022-03-16T02:18:07.242" v="640" actId="21"/>
          <ac:grpSpMkLst>
            <pc:docMk/>
            <pc:sldMk cId="3110800043" sldId="260"/>
            <ac:grpSpMk id="59" creationId="{6E9ABE71-983A-4714-A429-F798EA210BFE}"/>
          </ac:grpSpMkLst>
        </pc:grpChg>
        <pc:grpChg chg="mod">
          <ac:chgData name="Samantha Smith" userId="46674eb2fb326772" providerId="LiveId" clId="{9E3F6A57-789E-45D1-BCA1-F9DB26406392}" dt="2022-03-16T02:11:27.130" v="590"/>
          <ac:grpSpMkLst>
            <pc:docMk/>
            <pc:sldMk cId="3110800043" sldId="260"/>
            <ac:grpSpMk id="101" creationId="{DE13DA95-6552-4FC5-8222-51C31D348EE0}"/>
          </ac:grpSpMkLst>
        </pc:grpChg>
        <pc:grpChg chg="mod">
          <ac:chgData name="Samantha Smith" userId="46674eb2fb326772" providerId="LiveId" clId="{9E3F6A57-789E-45D1-BCA1-F9DB26406392}" dt="2022-03-16T02:11:27.130" v="590"/>
          <ac:grpSpMkLst>
            <pc:docMk/>
            <pc:sldMk cId="3110800043" sldId="260"/>
            <ac:grpSpMk id="109" creationId="{8E948A12-7D54-4CA5-9746-20229E89656F}"/>
          </ac:grpSpMkLst>
        </pc:grpChg>
        <pc:graphicFrameChg chg="add del mod modGraphic">
          <ac:chgData name="Samantha Smith" userId="46674eb2fb326772" providerId="LiveId" clId="{9E3F6A57-789E-45D1-BCA1-F9DB26406392}" dt="2022-03-16T02:18:07.242" v="640" actId="21"/>
          <ac:graphicFrameMkLst>
            <pc:docMk/>
            <pc:sldMk cId="3110800043" sldId="260"/>
            <ac:graphicFrameMk id="62" creationId="{18E73617-A898-4E9D-8289-F1E4DA665BD6}"/>
          </ac:graphicFrameMkLst>
        </pc:graphicFrame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6" creationId="{364BD797-ABC6-4F73-AC18-9CE32D9213DC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11" creationId="{D4B4A18B-B6D5-4E44-8CB8-B2708DA9B66F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12" creationId="{6CDA1FEF-8188-48CB-8837-84AC733437B6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13" creationId="{F4EAB4AE-1FAB-413D-8429-9BC1ADCC2C8D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14" creationId="{CA842F61-0827-400E-8312-B0DC9F1ABB87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15" creationId="{03858D37-2E40-4C63-AD3F-3D4540A90635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16" creationId="{A18F4953-F091-424A-9579-18CC58E9A339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17" creationId="{1A01D55D-B780-4216-8C43-DD1077FCE195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18" creationId="{D798CA9F-D369-4201-A56A-0193A3D1DB67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19" creationId="{D72F5767-2C53-4C71-BD17-084D25D16EA8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20" creationId="{643A76A5-6852-4287-8AAD-CD7B4AB40171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21" creationId="{26573719-7E97-427E-AFC3-011E55624E43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22" creationId="{6C1EBACD-1A32-4B41-8FD0-36B61C382D47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23" creationId="{39FB7161-3DBF-43E0-B38D-56DE3FF32527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24" creationId="{375ECCB1-89BE-437E-B4B6-7B86E531A84A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25" creationId="{30E87382-0713-4E1B-9C14-6B5A7A2C7224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26" creationId="{3E1599F7-9AC4-4402-8B19-72413250CABD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27" creationId="{ADBA3C25-3DCF-49A1-BBDB-CE7EC472ADED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30" creationId="{B15C9540-55A6-40C7-BF1B-7210D98AAFDD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31" creationId="{50B9BB75-DA68-4A55-A101-C1DBB5EB8B63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32" creationId="{C90E287E-6F6A-40B4-BA50-3171A35586F6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33" creationId="{6F05BAAD-6B53-44A6-A005-436A9C342B73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34" creationId="{80867D0E-ACDD-4AE2-8A72-61D33FA84022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35" creationId="{418055D5-4294-46B5-A7F2-6A5451BDBDE3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37" creationId="{F41EAA46-A83E-40EE-8A0E-8595EB0C5F62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42" creationId="{013AAD1A-80D7-4C04-9AE5-0186244FACDC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43" creationId="{AA1D6C72-545A-4E85-BCE0-9E8A0C4A9BE7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44" creationId="{09160470-86D0-4C59-B088-761A6ADC7EAA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45" creationId="{EC223791-6AAA-407C-A780-0B46F336CFEC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46" creationId="{7D7616EE-8BE0-4348-9065-117B720A78D2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47" creationId="{D9C87046-10DB-4A0F-9032-D412CA7583CF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48" creationId="{F33310E7-7DEE-4FA2-9475-A7DE64695BF4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49" creationId="{EEE55749-B8B7-44F4-B013-3EA3CD453C85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50" creationId="{BDD04B5C-1CA5-4766-B5B1-C0FA193A5308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51" creationId="{BCC75B57-96AA-4DDB-BEE9-DEB9C23D345A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52" creationId="{702F3CD4-2991-400C-90F2-A003058E2394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53" creationId="{64005DCE-6A32-49A4-9ECE-FCE7085A9B53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54" creationId="{C2FFC59B-D08B-4A81-8CDD-A4BF6E85184B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55" creationId="{72BC0200-6254-441B-A130-4456CDAAAD70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56" creationId="{77BB12AA-0246-48C1-AB65-4C70420A9855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57" creationId="{339BB835-F2C8-4B84-AB29-33ED5DCE50B0}"/>
          </ac:picMkLst>
        </pc:picChg>
        <pc:picChg chg="mod">
          <ac:chgData name="Samantha Smith" userId="46674eb2fb326772" providerId="LiveId" clId="{9E3F6A57-789E-45D1-BCA1-F9DB26406392}" dt="2022-03-16T02:14:43.231" v="609" actId="1076"/>
          <ac:picMkLst>
            <pc:docMk/>
            <pc:sldMk cId="3110800043" sldId="260"/>
            <ac:picMk id="58" creationId="{1FC12C48-2AB2-4A64-8D2F-0827849B8C44}"/>
          </ac:picMkLst>
        </pc:picChg>
        <pc:picChg chg="add del mod">
          <ac:chgData name="Samantha Smith" userId="46674eb2fb326772" providerId="LiveId" clId="{9E3F6A57-789E-45D1-BCA1-F9DB26406392}" dt="2022-03-16T02:18:07.242" v="640" actId="21"/>
          <ac:picMkLst>
            <pc:docMk/>
            <pc:sldMk cId="3110800043" sldId="260"/>
            <ac:picMk id="66" creationId="{8CA96E0C-9A15-4B84-9527-CEEB9380C636}"/>
          </ac:picMkLst>
        </pc:picChg>
        <pc:picChg chg="mod">
          <ac:chgData name="Samantha Smith" userId="46674eb2fb326772" providerId="LiveId" clId="{9E3F6A57-789E-45D1-BCA1-F9DB26406392}" dt="2022-03-16T02:11:27.130" v="590"/>
          <ac:picMkLst>
            <pc:docMk/>
            <pc:sldMk cId="3110800043" sldId="260"/>
            <ac:picMk id="94" creationId="{B4BEE763-3A67-4036-BBE6-FD1C31455623}"/>
          </ac:picMkLst>
        </pc:picChg>
        <pc:picChg chg="add del mod">
          <ac:chgData name="Samantha Smith" userId="46674eb2fb326772" providerId="LiveId" clId="{9E3F6A57-789E-45D1-BCA1-F9DB26406392}" dt="2022-03-16T02:18:07.242" v="640" actId="21"/>
          <ac:picMkLst>
            <pc:docMk/>
            <pc:sldMk cId="3110800043" sldId="260"/>
            <ac:picMk id="110" creationId="{028D7773-C7B8-4D08-88FC-725A82DAB53A}"/>
          </ac:picMkLst>
        </pc:picChg>
        <pc:picChg chg="add del mod">
          <ac:chgData name="Samantha Smith" userId="46674eb2fb326772" providerId="LiveId" clId="{9E3F6A57-789E-45D1-BCA1-F9DB26406392}" dt="2022-03-16T02:18:07.242" v="640" actId="21"/>
          <ac:picMkLst>
            <pc:docMk/>
            <pc:sldMk cId="3110800043" sldId="260"/>
            <ac:picMk id="1026" creationId="{A71CA7CC-5BCE-46D8-8A76-45902488E750}"/>
          </ac:picMkLst>
        </pc:picChg>
        <pc:picChg chg="add del mod">
          <ac:chgData name="Samantha Smith" userId="46674eb2fb326772" providerId="LiveId" clId="{9E3F6A57-789E-45D1-BCA1-F9DB26406392}" dt="2022-03-16T02:18:07.242" v="640" actId="21"/>
          <ac:picMkLst>
            <pc:docMk/>
            <pc:sldMk cId="3110800043" sldId="260"/>
            <ac:picMk id="1028" creationId="{45497346-D643-49A7-A929-F37508DCAD57}"/>
          </ac:picMkLst>
        </pc:picChg>
        <pc:cxnChg chg="mod">
          <ac:chgData name="Samantha Smith" userId="46674eb2fb326772" providerId="LiveId" clId="{9E3F6A57-789E-45D1-BCA1-F9DB26406392}" dt="2022-03-16T02:11:27.130" v="590"/>
          <ac:cxnSpMkLst>
            <pc:docMk/>
            <pc:sldMk cId="3110800043" sldId="260"/>
            <ac:cxnSpMk id="105" creationId="{70CC66C4-A782-4BB0-98AC-366A205BD81E}"/>
          </ac:cxnSpMkLst>
        </pc:cxnChg>
      </pc:sldChg>
      <pc:sldChg chg="del">
        <pc:chgData name="Samantha Smith" userId="46674eb2fb326772" providerId="LiveId" clId="{9E3F6A57-789E-45D1-BCA1-F9DB26406392}" dt="2022-02-06T04:48:58.387" v="1" actId="2696"/>
        <pc:sldMkLst>
          <pc:docMk/>
          <pc:sldMk cId="3602562773" sldId="261"/>
        </pc:sldMkLst>
      </pc:sldChg>
      <pc:sldChg chg="addSp modSp del mod">
        <pc:chgData name="Samantha Smith" userId="46674eb2fb326772" providerId="LiveId" clId="{9E3F6A57-789E-45D1-BCA1-F9DB26406392}" dt="2022-03-31T17:58:38.124" v="1052" actId="2696"/>
        <pc:sldMkLst>
          <pc:docMk/>
          <pc:sldMk cId="531607653" sldId="262"/>
        </pc:sldMkLst>
        <pc:spChg chg="add mod">
          <ac:chgData name="Samantha Smith" userId="46674eb2fb326772" providerId="LiveId" clId="{9E3F6A57-789E-45D1-BCA1-F9DB26406392}" dt="2022-03-16T03:37:09.455" v="759" actId="1076"/>
          <ac:spMkLst>
            <pc:docMk/>
            <pc:sldMk cId="531607653" sldId="262"/>
            <ac:spMk id="2" creationId="{6A60A998-706B-4FC6-867F-DC3AFEA1D0D3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531607653" sldId="262"/>
            <ac:spMk id="17" creationId="{080CD584-AECF-426B-B54B-570C23C7169D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531607653" sldId="262"/>
            <ac:spMk id="18" creationId="{966C5F25-C584-4D8D-80EB-BDDEA45A8B4E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531607653" sldId="262"/>
            <ac:spMk id="19" creationId="{420119C6-3294-4A66-B663-D1B124832D77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531607653" sldId="262"/>
            <ac:spMk id="20" creationId="{EC7F350E-B509-44AC-98E5-5E991EDCF7CE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531607653" sldId="262"/>
            <ac:spMk id="21" creationId="{DE223F32-CF5F-46E1-AA7C-218610D8ED4B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531607653" sldId="262"/>
            <ac:spMk id="22" creationId="{7873B232-F106-4640-BE26-F5E01BBB920F}"/>
          </ac:spMkLst>
        </pc:spChg>
        <pc:spChg chg="add mod">
          <ac:chgData name="Samantha Smith" userId="46674eb2fb326772" providerId="LiveId" clId="{9E3F6A57-789E-45D1-BCA1-F9DB26406392}" dt="2022-03-16T03:39:54.939" v="771" actId="1076"/>
          <ac:spMkLst>
            <pc:docMk/>
            <pc:sldMk cId="531607653" sldId="262"/>
            <ac:spMk id="23" creationId="{7CF9B40A-FDC1-46C5-A65A-47F4F13CBC95}"/>
          </ac:spMkLst>
        </pc:spChg>
        <pc:spChg chg="add mod">
          <ac:chgData name="Samantha Smith" userId="46674eb2fb326772" providerId="LiveId" clId="{9E3F6A57-789E-45D1-BCA1-F9DB26406392}" dt="2022-03-16T03:36:31.530" v="746" actId="20577"/>
          <ac:spMkLst>
            <pc:docMk/>
            <pc:sldMk cId="531607653" sldId="262"/>
            <ac:spMk id="24" creationId="{6D5CCFF2-87DB-448D-ADC3-812C6F41AE14}"/>
          </ac:spMkLst>
        </pc:spChg>
        <pc:spChg chg="add mod">
          <ac:chgData name="Samantha Smith" userId="46674eb2fb326772" providerId="LiveId" clId="{9E3F6A57-789E-45D1-BCA1-F9DB26406392}" dt="2022-03-16T03:39:48.602" v="770" actId="1076"/>
          <ac:spMkLst>
            <pc:docMk/>
            <pc:sldMk cId="531607653" sldId="262"/>
            <ac:spMk id="25" creationId="{EB83C3F2-C713-428C-A3A7-DE0FF0407A60}"/>
          </ac:spMkLst>
        </pc:spChg>
        <pc:spChg chg="add mod">
          <ac:chgData name="Samantha Smith" userId="46674eb2fb326772" providerId="LiveId" clId="{9E3F6A57-789E-45D1-BCA1-F9DB26406392}" dt="2022-03-16T03:40:06.656" v="772" actId="1076"/>
          <ac:spMkLst>
            <pc:docMk/>
            <pc:sldMk cId="531607653" sldId="262"/>
            <ac:spMk id="26" creationId="{6166CEB7-AF6F-4FC7-9030-7D204B105EAC}"/>
          </ac:spMkLst>
        </pc:spChg>
        <pc:spChg chg="add mod">
          <ac:chgData name="Samantha Smith" userId="46674eb2fb326772" providerId="LiveId" clId="{9E3F6A57-789E-45D1-BCA1-F9DB26406392}" dt="2022-03-16T03:38:13.288" v="766" actId="1076"/>
          <ac:spMkLst>
            <pc:docMk/>
            <pc:sldMk cId="531607653" sldId="262"/>
            <ac:spMk id="27" creationId="{E86DC254-E540-4AC0-87B7-D8245785B3BB}"/>
          </ac:spMkLst>
        </pc:spChg>
        <pc:graphicFrameChg chg="mod">
          <ac:chgData name="Samantha Smith" userId="46674eb2fb326772" providerId="LiveId" clId="{9E3F6A57-789E-45D1-BCA1-F9DB26406392}" dt="2022-03-16T03:42:04.190" v="773"/>
          <ac:graphicFrameMkLst>
            <pc:docMk/>
            <pc:sldMk cId="531607653" sldId="262"/>
            <ac:graphicFrameMk id="4" creationId="{2280FF32-C56D-4062-8E47-92E7AF688A51}"/>
          </ac:graphicFrameMkLst>
        </pc:graphicFrameChg>
        <pc:picChg chg="mod">
          <ac:chgData name="Samantha Smith" userId="46674eb2fb326772" providerId="LiveId" clId="{9E3F6A57-789E-45D1-BCA1-F9DB26406392}" dt="2022-03-16T02:11:27.130" v="590"/>
          <ac:picMkLst>
            <pc:docMk/>
            <pc:sldMk cId="531607653" sldId="262"/>
            <ac:picMk id="9" creationId="{99C3A950-6C83-458C-BC5E-3D0B9A4A0D7F}"/>
          </ac:picMkLst>
        </pc:picChg>
        <pc:picChg chg="mod">
          <ac:chgData name="Samantha Smith" userId="46674eb2fb326772" providerId="LiveId" clId="{9E3F6A57-789E-45D1-BCA1-F9DB26406392}" dt="2022-03-16T02:11:27.130" v="590"/>
          <ac:picMkLst>
            <pc:docMk/>
            <pc:sldMk cId="531607653" sldId="262"/>
            <ac:picMk id="10" creationId="{0EF58167-AFD8-48E4-8698-E6DC13A94617}"/>
          </ac:picMkLst>
        </pc:picChg>
        <pc:picChg chg="mod">
          <ac:chgData name="Samantha Smith" userId="46674eb2fb326772" providerId="LiveId" clId="{9E3F6A57-789E-45D1-BCA1-F9DB26406392}" dt="2022-03-16T02:11:27.130" v="590"/>
          <ac:picMkLst>
            <pc:docMk/>
            <pc:sldMk cId="531607653" sldId="262"/>
            <ac:picMk id="11" creationId="{36ACCA4C-F184-418F-B472-46F518A81F27}"/>
          </ac:picMkLst>
        </pc:picChg>
        <pc:picChg chg="mod">
          <ac:chgData name="Samantha Smith" userId="46674eb2fb326772" providerId="LiveId" clId="{9E3F6A57-789E-45D1-BCA1-F9DB26406392}" dt="2022-03-16T02:11:27.130" v="590"/>
          <ac:picMkLst>
            <pc:docMk/>
            <pc:sldMk cId="531607653" sldId="262"/>
            <ac:picMk id="12" creationId="{DC579A58-B4F4-4DEF-9B5A-065808351EAE}"/>
          </ac:picMkLst>
        </pc:picChg>
        <pc:picChg chg="mod">
          <ac:chgData name="Samantha Smith" userId="46674eb2fb326772" providerId="LiveId" clId="{9E3F6A57-789E-45D1-BCA1-F9DB26406392}" dt="2022-03-16T02:11:27.130" v="590"/>
          <ac:picMkLst>
            <pc:docMk/>
            <pc:sldMk cId="531607653" sldId="262"/>
            <ac:picMk id="13" creationId="{5C85937C-2014-4271-A0D9-87D48501E91B}"/>
          </ac:picMkLst>
        </pc:picChg>
        <pc:picChg chg="mod">
          <ac:chgData name="Samantha Smith" userId="46674eb2fb326772" providerId="LiveId" clId="{9E3F6A57-789E-45D1-BCA1-F9DB26406392}" dt="2022-03-16T02:11:27.130" v="590"/>
          <ac:picMkLst>
            <pc:docMk/>
            <pc:sldMk cId="531607653" sldId="262"/>
            <ac:picMk id="14" creationId="{153704D8-6B24-4B2F-99A9-6B3EF2986AB0}"/>
          </ac:picMkLst>
        </pc:picChg>
        <pc:cxnChg chg="mod">
          <ac:chgData name="Samantha Smith" userId="46674eb2fb326772" providerId="LiveId" clId="{9E3F6A57-789E-45D1-BCA1-F9DB26406392}" dt="2022-03-16T02:11:27.130" v="590"/>
          <ac:cxnSpMkLst>
            <pc:docMk/>
            <pc:sldMk cId="531607653" sldId="262"/>
            <ac:cxnSpMk id="15" creationId="{30871B92-6065-41C6-B131-FC2CB319617D}"/>
          </ac:cxnSpMkLst>
        </pc:cxnChg>
        <pc:cxnChg chg="mod">
          <ac:chgData name="Samantha Smith" userId="46674eb2fb326772" providerId="LiveId" clId="{9E3F6A57-789E-45D1-BCA1-F9DB26406392}" dt="2022-03-16T02:11:27.130" v="590"/>
          <ac:cxnSpMkLst>
            <pc:docMk/>
            <pc:sldMk cId="531607653" sldId="262"/>
            <ac:cxnSpMk id="16" creationId="{C80CC3B4-C3D8-4C84-8435-8EB4C47B5AC2}"/>
          </ac:cxnSpMkLst>
        </pc:cxnChg>
      </pc:sldChg>
      <pc:sldChg chg="addSp delSp modSp del mod">
        <pc:chgData name="Samantha Smith" userId="46674eb2fb326772" providerId="LiveId" clId="{9E3F6A57-789E-45D1-BCA1-F9DB26406392}" dt="2022-03-31T17:58:38.124" v="1052" actId="2696"/>
        <pc:sldMkLst>
          <pc:docMk/>
          <pc:sldMk cId="4057582585" sldId="263"/>
        </pc:sldMkLst>
        <pc:spChg chg="add mod">
          <ac:chgData name="Samantha Smith" userId="46674eb2fb326772" providerId="LiveId" clId="{9E3F6A57-789E-45D1-BCA1-F9DB26406392}" dt="2022-03-16T03:54:03.769" v="821" actId="1076"/>
          <ac:spMkLst>
            <pc:docMk/>
            <pc:sldMk cId="4057582585" sldId="263"/>
            <ac:spMk id="11" creationId="{C9F66AB6-3F59-4EB6-BE40-061E8423C63E}"/>
          </ac:spMkLst>
        </pc:spChg>
        <pc:spChg chg="add mod">
          <ac:chgData name="Samantha Smith" userId="46674eb2fb326772" providerId="LiveId" clId="{9E3F6A57-789E-45D1-BCA1-F9DB26406392}" dt="2022-03-16T03:52:38.286" v="797" actId="1076"/>
          <ac:spMkLst>
            <pc:docMk/>
            <pc:sldMk cId="4057582585" sldId="263"/>
            <ac:spMk id="13" creationId="{BF019671-9C55-4433-993D-80B24997F3CC}"/>
          </ac:spMkLst>
        </pc:spChg>
        <pc:spChg chg="add mod">
          <ac:chgData name="Samantha Smith" userId="46674eb2fb326772" providerId="LiveId" clId="{9E3F6A57-789E-45D1-BCA1-F9DB26406392}" dt="2022-03-16T03:52:41.927" v="799" actId="1076"/>
          <ac:spMkLst>
            <pc:docMk/>
            <pc:sldMk cId="4057582585" sldId="263"/>
            <ac:spMk id="14" creationId="{9DCDE2E1-48AF-4EFC-9F05-49C68205E2C8}"/>
          </ac:spMkLst>
        </pc:spChg>
        <pc:spChg chg="add del mod">
          <ac:chgData name="Samantha Smith" userId="46674eb2fb326772" providerId="LiveId" clId="{9E3F6A57-789E-45D1-BCA1-F9DB26406392}" dt="2022-03-16T03:53:17.504" v="814" actId="478"/>
          <ac:spMkLst>
            <pc:docMk/>
            <pc:sldMk cId="4057582585" sldId="263"/>
            <ac:spMk id="15" creationId="{A726999F-7632-470D-B9D2-C3468F43F725}"/>
          </ac:spMkLst>
        </pc:spChg>
        <pc:spChg chg="add mod">
          <ac:chgData name="Samantha Smith" userId="46674eb2fb326772" providerId="LiveId" clId="{9E3F6A57-789E-45D1-BCA1-F9DB26406392}" dt="2022-03-16T03:52:50.646" v="803" actId="1076"/>
          <ac:spMkLst>
            <pc:docMk/>
            <pc:sldMk cId="4057582585" sldId="263"/>
            <ac:spMk id="16" creationId="{CB630A96-8288-4D0C-9849-490ACE5F8348}"/>
          </ac:spMkLst>
        </pc:spChg>
        <pc:spChg chg="add mod">
          <ac:chgData name="Samantha Smith" userId="46674eb2fb326772" providerId="LiveId" clId="{9E3F6A57-789E-45D1-BCA1-F9DB26406392}" dt="2022-03-16T03:54:25.781" v="837" actId="1036"/>
          <ac:spMkLst>
            <pc:docMk/>
            <pc:sldMk cId="4057582585" sldId="263"/>
            <ac:spMk id="21" creationId="{C5BBCCF1-C5FF-4C9D-9D48-5AA045EF4353}"/>
          </ac:spMkLst>
        </pc:spChg>
        <pc:spChg chg="add mod">
          <ac:chgData name="Samantha Smith" userId="46674eb2fb326772" providerId="LiveId" clId="{9E3F6A57-789E-45D1-BCA1-F9DB26406392}" dt="2022-03-16T03:54:09.156" v="822" actId="1076"/>
          <ac:spMkLst>
            <pc:docMk/>
            <pc:sldMk cId="4057582585" sldId="263"/>
            <ac:spMk id="22" creationId="{D07E8165-DEA3-47D7-B94B-227A516286B7}"/>
          </ac:spMkLst>
        </pc:spChg>
        <pc:graphicFrameChg chg="mod">
          <ac:chgData name="Samantha Smith" userId="46674eb2fb326772" providerId="LiveId" clId="{9E3F6A57-789E-45D1-BCA1-F9DB26406392}" dt="2022-03-16T03:53:41.966" v="820"/>
          <ac:graphicFrameMkLst>
            <pc:docMk/>
            <pc:sldMk cId="4057582585" sldId="263"/>
            <ac:graphicFrameMk id="4" creationId="{55B5FB00-8FA6-4626-83B4-B3D6BA00FC1E}"/>
          </ac:graphicFrameMkLst>
        </pc:graphicFrameChg>
        <pc:picChg chg="mod">
          <ac:chgData name="Samantha Smith" userId="46674eb2fb326772" providerId="LiveId" clId="{9E3F6A57-789E-45D1-BCA1-F9DB26406392}" dt="2022-03-16T02:11:27.130" v="590"/>
          <ac:picMkLst>
            <pc:docMk/>
            <pc:sldMk cId="4057582585" sldId="263"/>
            <ac:picMk id="6" creationId="{1155A702-A329-4156-9CA6-E76CA829449F}"/>
          </ac:picMkLst>
        </pc:picChg>
        <pc:picChg chg="mod">
          <ac:chgData name="Samantha Smith" userId="46674eb2fb326772" providerId="LiveId" clId="{9E3F6A57-789E-45D1-BCA1-F9DB26406392}" dt="2022-03-16T02:11:27.130" v="590"/>
          <ac:picMkLst>
            <pc:docMk/>
            <pc:sldMk cId="4057582585" sldId="263"/>
            <ac:picMk id="8" creationId="{E570D12E-FCF5-4AEA-A3AC-7DAA8CCB72C3}"/>
          </ac:picMkLst>
        </pc:picChg>
        <pc:picChg chg="mod">
          <ac:chgData name="Samantha Smith" userId="46674eb2fb326772" providerId="LiveId" clId="{9E3F6A57-789E-45D1-BCA1-F9DB26406392}" dt="2022-03-16T02:11:27.130" v="590"/>
          <ac:picMkLst>
            <pc:docMk/>
            <pc:sldMk cId="4057582585" sldId="263"/>
            <ac:picMk id="10" creationId="{F9874262-6D52-404C-9B1E-112D3694D1A2}"/>
          </ac:picMkLst>
        </pc:picChg>
        <pc:picChg chg="mod">
          <ac:chgData name="Samantha Smith" userId="46674eb2fb326772" providerId="LiveId" clId="{9E3F6A57-789E-45D1-BCA1-F9DB26406392}" dt="2022-03-16T02:11:27.130" v="590"/>
          <ac:picMkLst>
            <pc:docMk/>
            <pc:sldMk cId="4057582585" sldId="263"/>
            <ac:picMk id="12" creationId="{24812591-60F1-4ED6-AB9B-78439DD44A52}"/>
          </ac:picMkLst>
        </pc:picChg>
        <pc:picChg chg="mod">
          <ac:chgData name="Samantha Smith" userId="46674eb2fb326772" providerId="LiveId" clId="{9E3F6A57-789E-45D1-BCA1-F9DB26406392}" dt="2022-03-16T02:11:27.130" v="590"/>
          <ac:picMkLst>
            <pc:docMk/>
            <pc:sldMk cId="4057582585" sldId="263"/>
            <ac:picMk id="17" creationId="{FEF64A25-B7A4-4158-A6AA-A00E3475E28C}"/>
          </ac:picMkLst>
        </pc:picChg>
        <pc:picChg chg="mod">
          <ac:chgData name="Samantha Smith" userId="46674eb2fb326772" providerId="LiveId" clId="{9E3F6A57-789E-45D1-BCA1-F9DB26406392}" dt="2022-03-16T02:11:27.130" v="590"/>
          <ac:picMkLst>
            <pc:docMk/>
            <pc:sldMk cId="4057582585" sldId="263"/>
            <ac:picMk id="18" creationId="{9E42F290-5CE6-4680-8F6F-878E7A446305}"/>
          </ac:picMkLst>
        </pc:picChg>
        <pc:cxnChg chg="mod">
          <ac:chgData name="Samantha Smith" userId="46674eb2fb326772" providerId="LiveId" clId="{9E3F6A57-789E-45D1-BCA1-F9DB26406392}" dt="2022-03-16T02:11:27.130" v="590"/>
          <ac:cxnSpMkLst>
            <pc:docMk/>
            <pc:sldMk cId="4057582585" sldId="263"/>
            <ac:cxnSpMk id="19" creationId="{925EBC2C-745E-4017-90BE-B27966C999D9}"/>
          </ac:cxnSpMkLst>
        </pc:cxnChg>
        <pc:cxnChg chg="mod">
          <ac:chgData name="Samantha Smith" userId="46674eb2fb326772" providerId="LiveId" clId="{9E3F6A57-789E-45D1-BCA1-F9DB26406392}" dt="2022-03-16T02:11:27.130" v="590"/>
          <ac:cxnSpMkLst>
            <pc:docMk/>
            <pc:sldMk cId="4057582585" sldId="263"/>
            <ac:cxnSpMk id="20" creationId="{038E9052-5FB1-478E-A839-16F5EBECAD34}"/>
          </ac:cxnSpMkLst>
        </pc:cxnChg>
      </pc:sldChg>
      <pc:sldChg chg="delSp modSp del mod">
        <pc:chgData name="Samantha Smith" userId="46674eb2fb326772" providerId="LiveId" clId="{9E3F6A57-789E-45D1-BCA1-F9DB26406392}" dt="2022-03-31T17:58:38.124" v="1052" actId="2696"/>
        <pc:sldMkLst>
          <pc:docMk/>
          <pc:sldMk cId="4264966930" sldId="264"/>
        </pc:sldMkLst>
        <pc:graphicFrameChg chg="del mod">
          <ac:chgData name="Samantha Smith" userId="46674eb2fb326772" providerId="LiveId" clId="{9E3F6A57-789E-45D1-BCA1-F9DB26406392}" dt="2022-03-11T18:24:47.337" v="582" actId="478"/>
          <ac:graphicFrameMkLst>
            <pc:docMk/>
            <pc:sldMk cId="4264966930" sldId="264"/>
            <ac:graphicFrameMk id="2" creationId="{C8E47C1B-2F34-4C48-91DB-000E8563EF23}"/>
          </ac:graphicFrameMkLst>
        </pc:graphicFrameChg>
        <pc:graphicFrameChg chg="mod">
          <ac:chgData name="Samantha Smith" userId="46674eb2fb326772" providerId="LiveId" clId="{9E3F6A57-789E-45D1-BCA1-F9DB26406392}" dt="2022-03-16T02:11:27.130" v="590"/>
          <ac:graphicFrameMkLst>
            <pc:docMk/>
            <pc:sldMk cId="4264966930" sldId="264"/>
            <ac:graphicFrameMk id="6" creationId="{5F3B34BD-0555-4936-9B68-B3F2426A1EBE}"/>
          </ac:graphicFrameMkLst>
        </pc:graphicFrameChg>
      </pc:sldChg>
      <pc:sldChg chg="addSp delSp modSp del mod">
        <pc:chgData name="Samantha Smith" userId="46674eb2fb326772" providerId="LiveId" clId="{9E3F6A57-789E-45D1-BCA1-F9DB26406392}" dt="2022-03-31T17:58:38.124" v="1052" actId="2696"/>
        <pc:sldMkLst>
          <pc:docMk/>
          <pc:sldMk cId="538272696" sldId="265"/>
        </pc:sldMkLst>
        <pc:graphicFrameChg chg="add mod">
          <ac:chgData name="Samantha Smith" userId="46674eb2fb326772" providerId="LiveId" clId="{9E3F6A57-789E-45D1-BCA1-F9DB26406392}" dt="2022-03-16T02:11:27.130" v="590"/>
          <ac:graphicFrameMkLst>
            <pc:docMk/>
            <pc:sldMk cId="538272696" sldId="265"/>
            <ac:graphicFrameMk id="2" creationId="{98956E6A-B27D-4C87-97CD-BE314B0E622C}"/>
          </ac:graphicFrameMkLst>
        </pc:graphicFrameChg>
        <pc:graphicFrameChg chg="del mod">
          <ac:chgData name="Samantha Smith" userId="46674eb2fb326772" providerId="LiveId" clId="{9E3F6A57-789E-45D1-BCA1-F9DB26406392}" dt="2022-03-08T22:56:57.002" v="36" actId="478"/>
          <ac:graphicFrameMkLst>
            <pc:docMk/>
            <pc:sldMk cId="538272696" sldId="265"/>
            <ac:graphicFrameMk id="4" creationId="{1B4F3237-A609-4B7F-9B77-C26A368108C0}"/>
          </ac:graphicFrameMkLst>
        </pc:graphicFrameChg>
      </pc:sldChg>
      <pc:sldChg chg="modSp del mod">
        <pc:chgData name="Samantha Smith" userId="46674eb2fb326772" providerId="LiveId" clId="{9E3F6A57-789E-45D1-BCA1-F9DB26406392}" dt="2022-03-31T17:58:38.124" v="1052" actId="2696"/>
        <pc:sldMkLst>
          <pc:docMk/>
          <pc:sldMk cId="2599844239" sldId="266"/>
        </pc:sldMkLst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2599844239" sldId="266"/>
            <ac:spMk id="4" creationId="{7FA5BC29-8B6F-40C8-9084-917D2549E1BF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2599844239" sldId="266"/>
            <ac:spMk id="5" creationId="{DB393044-1794-4FAB-A221-202F6A34506E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2599844239" sldId="266"/>
            <ac:spMk id="6" creationId="{3D9183AF-4C25-4D08-BB30-C9DCAC015E3E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2599844239" sldId="266"/>
            <ac:spMk id="8" creationId="{B1E8A765-B754-4C7A-80DF-C47BEF88614F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2599844239" sldId="266"/>
            <ac:spMk id="9" creationId="{1A883BAA-8912-4690-A894-7B9C1CB90705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2599844239" sldId="266"/>
            <ac:spMk id="10" creationId="{1077A1CF-7855-4B44-A37A-75EE1F55CF95}"/>
          </ac:spMkLst>
        </pc:spChg>
        <pc:graphicFrameChg chg="mod modGraphic">
          <ac:chgData name="Samantha Smith" userId="46674eb2fb326772" providerId="LiveId" clId="{9E3F6A57-789E-45D1-BCA1-F9DB26406392}" dt="2022-03-16T02:11:27.130" v="590"/>
          <ac:graphicFrameMkLst>
            <pc:docMk/>
            <pc:sldMk cId="2599844239" sldId="266"/>
            <ac:graphicFrameMk id="7" creationId="{6918F482-22F7-4DBF-919F-68C75D6693C1}"/>
          </ac:graphicFrameMkLst>
        </pc:graphicFrameChg>
        <pc:picChg chg="mod">
          <ac:chgData name="Samantha Smith" userId="46674eb2fb326772" providerId="LiveId" clId="{9E3F6A57-789E-45D1-BCA1-F9DB26406392}" dt="2022-03-16T02:11:27.130" v="590"/>
          <ac:picMkLst>
            <pc:docMk/>
            <pc:sldMk cId="2599844239" sldId="266"/>
            <ac:picMk id="8193" creationId="{04C74533-57E7-425D-9F25-26778E0679EA}"/>
          </ac:picMkLst>
        </pc:picChg>
      </pc:sldChg>
      <pc:sldChg chg="modSp del mod">
        <pc:chgData name="Samantha Smith" userId="46674eb2fb326772" providerId="LiveId" clId="{9E3F6A57-789E-45D1-BCA1-F9DB26406392}" dt="2022-03-31T17:58:38.124" v="1052" actId="2696"/>
        <pc:sldMkLst>
          <pc:docMk/>
          <pc:sldMk cId="669967950" sldId="267"/>
        </pc:sldMkLst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669967950" sldId="267"/>
            <ac:spMk id="7" creationId="{08CEF6BD-0BE3-4DFC-BD91-33ED1CD8E028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669967950" sldId="267"/>
            <ac:spMk id="8" creationId="{08A7D352-6319-41A0-8E1A-C15AEC1804ED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k cId="669967950" sldId="267"/>
            <ac:spMk id="9" creationId="{019B0522-86E7-4FD5-9D10-E4BE97297099}"/>
          </ac:spMkLst>
        </pc:spChg>
        <pc:graphicFrameChg chg="mod modGraphic">
          <ac:chgData name="Samantha Smith" userId="46674eb2fb326772" providerId="LiveId" clId="{9E3F6A57-789E-45D1-BCA1-F9DB26406392}" dt="2022-03-16T02:11:27.130" v="590"/>
          <ac:graphicFrameMkLst>
            <pc:docMk/>
            <pc:sldMk cId="669967950" sldId="267"/>
            <ac:graphicFrameMk id="10" creationId="{11F0DC09-56F2-400D-9324-575EFB11FE42}"/>
          </ac:graphicFrameMkLst>
        </pc:graphicFrameChg>
        <pc:picChg chg="mod">
          <ac:chgData name="Samantha Smith" userId="46674eb2fb326772" providerId="LiveId" clId="{9E3F6A57-789E-45D1-BCA1-F9DB26406392}" dt="2022-03-16T02:11:27.130" v="590"/>
          <ac:picMkLst>
            <pc:docMk/>
            <pc:sldMk cId="669967950" sldId="267"/>
            <ac:picMk id="4" creationId="{C4EE49F9-E2CE-4785-AAF4-5469B61783F4}"/>
          </ac:picMkLst>
        </pc:picChg>
      </pc:sldChg>
      <pc:sldChg chg="addSp delSp modSp new del mod">
        <pc:chgData name="Samantha Smith" userId="46674eb2fb326772" providerId="LiveId" clId="{9E3F6A57-789E-45D1-BCA1-F9DB26406392}" dt="2022-03-31T17:58:38.124" v="1052" actId="2696"/>
        <pc:sldMkLst>
          <pc:docMk/>
          <pc:sldMk cId="1008563263" sldId="268"/>
        </pc:sldMkLst>
        <pc:spChg chg="del">
          <ac:chgData name="Samantha Smith" userId="46674eb2fb326772" providerId="LiveId" clId="{9E3F6A57-789E-45D1-BCA1-F9DB26406392}" dt="2022-03-10T21:23:38.371" v="64" actId="478"/>
          <ac:spMkLst>
            <pc:docMk/>
            <pc:sldMk cId="1008563263" sldId="268"/>
            <ac:spMk id="2" creationId="{BEAFA35C-7380-4711-9E3E-47E5D656D7A1}"/>
          </ac:spMkLst>
        </pc:spChg>
        <pc:spChg chg="del">
          <ac:chgData name="Samantha Smith" userId="46674eb2fb326772" providerId="LiveId" clId="{9E3F6A57-789E-45D1-BCA1-F9DB26406392}" dt="2022-03-10T21:23:37.257" v="63" actId="478"/>
          <ac:spMkLst>
            <pc:docMk/>
            <pc:sldMk cId="1008563263" sldId="268"/>
            <ac:spMk id="3" creationId="{B52C19B1-FD38-4513-83C2-5A7148913705}"/>
          </ac:spMkLst>
        </pc:spChg>
        <pc:spChg chg="add mod">
          <ac:chgData name="Samantha Smith" userId="46674eb2fb326772" providerId="LiveId" clId="{9E3F6A57-789E-45D1-BCA1-F9DB26406392}" dt="2022-03-16T04:43:31.805" v="854" actId="20577"/>
          <ac:spMkLst>
            <pc:docMk/>
            <pc:sldMk cId="1008563263" sldId="268"/>
            <ac:spMk id="6" creationId="{07D7199B-9AEC-4BF8-AE16-AF7F199D60A7}"/>
          </ac:spMkLst>
        </pc:spChg>
        <pc:spChg chg="add del">
          <ac:chgData name="Samantha Smith" userId="46674eb2fb326772" providerId="LiveId" clId="{9E3F6A57-789E-45D1-BCA1-F9DB26406392}" dt="2022-03-10T21:27:46.884" v="95"/>
          <ac:spMkLst>
            <pc:docMk/>
            <pc:sldMk cId="1008563263" sldId="268"/>
            <ac:spMk id="6" creationId="{6F77B59F-269D-4354-AE32-17FE8643E339}"/>
          </ac:spMkLst>
        </pc:spChg>
        <pc:spChg chg="add del mod ord">
          <ac:chgData name="Samantha Smith" userId="46674eb2fb326772" providerId="LiveId" clId="{9E3F6A57-789E-45D1-BCA1-F9DB26406392}" dt="2022-03-10T21:27:46.884" v="95"/>
          <ac:spMkLst>
            <pc:docMk/>
            <pc:sldMk cId="1008563263" sldId="268"/>
            <ac:spMk id="7" creationId="{07BC17A4-157D-4C05-939C-18A61BDF3293}"/>
          </ac:spMkLst>
        </pc:spChg>
        <pc:spChg chg="add mod">
          <ac:chgData name="Samantha Smith" userId="46674eb2fb326772" providerId="LiveId" clId="{9E3F6A57-789E-45D1-BCA1-F9DB26406392}" dt="2022-03-16T05:04:52.520" v="861" actId="20577"/>
          <ac:spMkLst>
            <pc:docMk/>
            <pc:sldMk cId="1008563263" sldId="268"/>
            <ac:spMk id="7" creationId="{C6978DE8-F56F-49FE-818A-780A7344E660}"/>
          </ac:spMkLst>
        </pc:spChg>
        <pc:spChg chg="add del">
          <ac:chgData name="Samantha Smith" userId="46674eb2fb326772" providerId="LiveId" clId="{9E3F6A57-789E-45D1-BCA1-F9DB26406392}" dt="2022-03-10T21:27:46.884" v="95"/>
          <ac:spMkLst>
            <pc:docMk/>
            <pc:sldMk cId="1008563263" sldId="268"/>
            <ac:spMk id="8" creationId="{C2235ADD-301D-4852-9ABF-49C69AAB424B}"/>
          </ac:spMkLst>
        </pc:spChg>
        <pc:spChg chg="add del">
          <ac:chgData name="Samantha Smith" userId="46674eb2fb326772" providerId="LiveId" clId="{9E3F6A57-789E-45D1-BCA1-F9DB26406392}" dt="2022-03-10T21:27:46.884" v="95"/>
          <ac:spMkLst>
            <pc:docMk/>
            <pc:sldMk cId="1008563263" sldId="268"/>
            <ac:spMk id="9" creationId="{9B6EB647-544A-4B1F-8359-393C0BDBF7F3}"/>
          </ac:spMkLst>
        </pc:spChg>
        <pc:spChg chg="add del">
          <ac:chgData name="Samantha Smith" userId="46674eb2fb326772" providerId="LiveId" clId="{9E3F6A57-789E-45D1-BCA1-F9DB26406392}" dt="2022-03-10T21:27:46.884" v="95"/>
          <ac:spMkLst>
            <pc:docMk/>
            <pc:sldMk cId="1008563263" sldId="268"/>
            <ac:spMk id="10" creationId="{FB903723-F74D-4FF2-A81C-40691D2C3B33}"/>
          </ac:spMkLst>
        </pc:spChg>
        <pc:spChg chg="add del">
          <ac:chgData name="Samantha Smith" userId="46674eb2fb326772" providerId="LiveId" clId="{9E3F6A57-789E-45D1-BCA1-F9DB26406392}" dt="2022-03-10T21:27:46.884" v="95"/>
          <ac:spMkLst>
            <pc:docMk/>
            <pc:sldMk cId="1008563263" sldId="268"/>
            <ac:spMk id="11" creationId="{513F212B-E082-4D46-BFC3-488BA4DBFE51}"/>
          </ac:spMkLst>
        </pc:spChg>
        <pc:spChg chg="add del">
          <ac:chgData name="Samantha Smith" userId="46674eb2fb326772" providerId="LiveId" clId="{9E3F6A57-789E-45D1-BCA1-F9DB26406392}" dt="2022-03-10T21:27:46.884" v="95"/>
          <ac:spMkLst>
            <pc:docMk/>
            <pc:sldMk cId="1008563263" sldId="268"/>
            <ac:spMk id="12" creationId="{56C0070D-6B63-45B8-9636-66BA5078D010}"/>
          </ac:spMkLst>
        </pc:spChg>
        <pc:spChg chg="add del">
          <ac:chgData name="Samantha Smith" userId="46674eb2fb326772" providerId="LiveId" clId="{9E3F6A57-789E-45D1-BCA1-F9DB26406392}" dt="2022-03-10T21:27:46.884" v="95"/>
          <ac:spMkLst>
            <pc:docMk/>
            <pc:sldMk cId="1008563263" sldId="268"/>
            <ac:spMk id="13" creationId="{EA259B27-5C67-4F74-B7E4-3E0871F4F63A}"/>
          </ac:spMkLst>
        </pc:spChg>
        <pc:spChg chg="add del">
          <ac:chgData name="Samantha Smith" userId="46674eb2fb326772" providerId="LiveId" clId="{9E3F6A57-789E-45D1-BCA1-F9DB26406392}" dt="2022-03-10T21:27:46.884" v="95"/>
          <ac:spMkLst>
            <pc:docMk/>
            <pc:sldMk cId="1008563263" sldId="268"/>
            <ac:spMk id="14" creationId="{07C73B56-370B-48D2-BBFF-110E5A6D1761}"/>
          </ac:spMkLst>
        </pc:spChg>
        <pc:spChg chg="add del">
          <ac:chgData name="Samantha Smith" userId="46674eb2fb326772" providerId="LiveId" clId="{9E3F6A57-789E-45D1-BCA1-F9DB26406392}" dt="2022-03-10T21:27:46.884" v="95"/>
          <ac:spMkLst>
            <pc:docMk/>
            <pc:sldMk cId="1008563263" sldId="268"/>
            <ac:spMk id="15" creationId="{0C000375-3FF2-4E60-BA86-32BF05E55722}"/>
          </ac:spMkLst>
        </pc:spChg>
        <pc:spChg chg="add del">
          <ac:chgData name="Samantha Smith" userId="46674eb2fb326772" providerId="LiveId" clId="{9E3F6A57-789E-45D1-BCA1-F9DB26406392}" dt="2022-03-10T21:27:46.884" v="95"/>
          <ac:spMkLst>
            <pc:docMk/>
            <pc:sldMk cId="1008563263" sldId="268"/>
            <ac:spMk id="16" creationId="{774A46D3-6B72-445D-995D-CA300CB0C1FE}"/>
          </ac:spMkLst>
        </pc:spChg>
        <pc:spChg chg="add del">
          <ac:chgData name="Samantha Smith" userId="46674eb2fb326772" providerId="LiveId" clId="{9E3F6A57-789E-45D1-BCA1-F9DB26406392}" dt="2022-03-10T21:27:46.884" v="95"/>
          <ac:spMkLst>
            <pc:docMk/>
            <pc:sldMk cId="1008563263" sldId="268"/>
            <ac:spMk id="17" creationId="{0537F20F-A3EE-4A32-9344-860F4F42EE7B}"/>
          </ac:spMkLst>
        </pc:spChg>
        <pc:spChg chg="add del">
          <ac:chgData name="Samantha Smith" userId="46674eb2fb326772" providerId="LiveId" clId="{9E3F6A57-789E-45D1-BCA1-F9DB26406392}" dt="2022-03-10T21:27:46.884" v="95"/>
          <ac:spMkLst>
            <pc:docMk/>
            <pc:sldMk cId="1008563263" sldId="268"/>
            <ac:spMk id="18" creationId="{8A6900B4-8BF0-4152-90DA-FEB3B13BF097}"/>
          </ac:spMkLst>
        </pc:spChg>
        <pc:spChg chg="add del">
          <ac:chgData name="Samantha Smith" userId="46674eb2fb326772" providerId="LiveId" clId="{9E3F6A57-789E-45D1-BCA1-F9DB26406392}" dt="2022-03-10T21:27:46.884" v="95"/>
          <ac:spMkLst>
            <pc:docMk/>
            <pc:sldMk cId="1008563263" sldId="268"/>
            <ac:spMk id="19" creationId="{69BEC1BA-E57B-41A5-B563-57BAC5C5227E}"/>
          </ac:spMkLst>
        </pc:spChg>
        <pc:graphicFrameChg chg="add del mod">
          <ac:chgData name="Samantha Smith" userId="46674eb2fb326772" providerId="LiveId" clId="{9E3F6A57-789E-45D1-BCA1-F9DB26406392}" dt="2022-03-10T21:23:55.532" v="78"/>
          <ac:graphicFrameMkLst>
            <pc:docMk/>
            <pc:sldMk cId="1008563263" sldId="268"/>
            <ac:graphicFrameMk id="4" creationId="{5ED6A93A-FAEA-44A4-97DF-671923E5EA49}"/>
          </ac:graphicFrameMkLst>
        </pc:graphicFrameChg>
        <pc:graphicFrameChg chg="add mod modGraphic">
          <ac:chgData name="Samantha Smith" userId="46674eb2fb326772" providerId="LiveId" clId="{9E3F6A57-789E-45D1-BCA1-F9DB26406392}" dt="2022-03-16T05:06:46.620" v="866" actId="1076"/>
          <ac:graphicFrameMkLst>
            <pc:docMk/>
            <pc:sldMk cId="1008563263" sldId="268"/>
            <ac:graphicFrameMk id="5" creationId="{8FCEFBA7-F481-474B-9D74-0019AF821B64}"/>
          </ac:graphicFrameMkLst>
        </pc:graphicFrameChg>
        <pc:graphicFrameChg chg="add mod modGraphic">
          <ac:chgData name="Samantha Smith" userId="46674eb2fb326772" providerId="LiveId" clId="{9E3F6A57-789E-45D1-BCA1-F9DB26406392}" dt="2022-03-16T04:41:08.450" v="850" actId="1076"/>
          <ac:graphicFrameMkLst>
            <pc:docMk/>
            <pc:sldMk cId="1008563263" sldId="268"/>
            <ac:graphicFrameMk id="21" creationId="{BBC9C696-C946-4224-B0D4-788CB6C1BF30}"/>
          </ac:graphicFrameMkLst>
        </pc:graphicFrameChg>
        <pc:picChg chg="add mod">
          <ac:chgData name="Samantha Smith" userId="46674eb2fb326772" providerId="LiveId" clId="{9E3F6A57-789E-45D1-BCA1-F9DB26406392}" dt="2022-03-16T05:04:43.988" v="860" actId="14100"/>
          <ac:picMkLst>
            <pc:docMk/>
            <pc:sldMk cId="1008563263" sldId="268"/>
            <ac:picMk id="2" creationId="{86961EC3-0899-4965-A56A-5EC77009B0DE}"/>
          </ac:picMkLst>
        </pc:picChg>
        <pc:picChg chg="add del mod modCrop">
          <ac:chgData name="Samantha Smith" userId="46674eb2fb326772" providerId="LiveId" clId="{9E3F6A57-789E-45D1-BCA1-F9DB26406392}" dt="2022-03-16T04:30:34.413" v="840" actId="478"/>
          <ac:picMkLst>
            <pc:docMk/>
            <pc:sldMk cId="1008563263" sldId="268"/>
            <ac:picMk id="20" creationId="{EE74A40D-CBD3-4CDD-A9F4-24AB5AD04A26}"/>
          </ac:picMkLst>
        </pc:picChg>
        <pc:picChg chg="add del">
          <ac:chgData name="Samantha Smith" userId="46674eb2fb326772" providerId="LiveId" clId="{9E3F6A57-789E-45D1-BCA1-F9DB26406392}" dt="2022-03-10T21:27:46.884" v="95"/>
          <ac:picMkLst>
            <pc:docMk/>
            <pc:sldMk cId="1008563263" sldId="268"/>
            <ac:picMk id="1025" creationId="{D03E7A13-C592-4AF2-8008-1FA0B83C566C}"/>
          </ac:picMkLst>
        </pc:picChg>
      </pc:sldChg>
      <pc:sldChg chg="addSp delSp modSp mod">
        <pc:chgData name="Samantha Smith" userId="46674eb2fb326772" providerId="LiveId" clId="{9E3F6A57-789E-45D1-BCA1-F9DB26406392}" dt="2022-04-04T21:40:55.084" v="1241" actId="1076"/>
        <pc:sldMkLst>
          <pc:docMk/>
          <pc:sldMk cId="3208828586" sldId="270"/>
        </pc:sldMkLst>
        <pc:spChg chg="add mod">
          <ac:chgData name="Samantha Smith" userId="46674eb2fb326772" providerId="LiveId" clId="{9E3F6A57-789E-45D1-BCA1-F9DB26406392}" dt="2022-04-01T16:06:32.415" v="1102" actId="164"/>
          <ac:spMkLst>
            <pc:docMk/>
            <pc:sldMk cId="3208828586" sldId="270"/>
            <ac:spMk id="4" creationId="{A804DC5F-566F-4FC6-9F27-EA6F6F1C9A9D}"/>
          </ac:spMkLst>
        </pc:spChg>
        <pc:spChg chg="add mod">
          <ac:chgData name="Samantha Smith" userId="46674eb2fb326772" providerId="LiveId" clId="{9E3F6A57-789E-45D1-BCA1-F9DB26406392}" dt="2022-04-04T21:40:50.978" v="1239" actId="164"/>
          <ac:spMkLst>
            <pc:docMk/>
            <pc:sldMk cId="3208828586" sldId="270"/>
            <ac:spMk id="9" creationId="{A077A390-5292-45C9-8272-54437143946B}"/>
          </ac:spMkLst>
        </pc:spChg>
        <pc:grpChg chg="add del mod">
          <ac:chgData name="Samantha Smith" userId="46674eb2fb326772" providerId="LiveId" clId="{9E3F6A57-789E-45D1-BCA1-F9DB26406392}" dt="2022-04-04T21:40:26.652" v="1227" actId="478"/>
          <ac:grpSpMkLst>
            <pc:docMk/>
            <pc:sldMk cId="3208828586" sldId="270"/>
            <ac:grpSpMk id="5" creationId="{0AE903F3-5CA0-403C-9AC0-151AF60A36E0}"/>
          </ac:grpSpMkLst>
        </pc:grpChg>
        <pc:grpChg chg="add mod">
          <ac:chgData name="Samantha Smith" userId="46674eb2fb326772" providerId="LiveId" clId="{9E3F6A57-789E-45D1-BCA1-F9DB26406392}" dt="2022-04-04T21:40:55.084" v="1241" actId="1076"/>
          <ac:grpSpMkLst>
            <pc:docMk/>
            <pc:sldMk cId="3208828586" sldId="270"/>
            <ac:grpSpMk id="10" creationId="{CDF6BC61-1B45-4E0B-8F8B-D38E2CDCE16B}"/>
          </ac:grpSpMkLst>
        </pc:grpChg>
        <pc:picChg chg="add mod">
          <ac:chgData name="Samantha Smith" userId="46674eb2fb326772" providerId="LiveId" clId="{9E3F6A57-789E-45D1-BCA1-F9DB26406392}" dt="2022-04-01T16:06:32.415" v="1102" actId="164"/>
          <ac:picMkLst>
            <pc:docMk/>
            <pc:sldMk cId="3208828586" sldId="270"/>
            <ac:picMk id="3" creationId="{37B57F65-6857-4820-BDF4-96E15D3C31AF}"/>
          </ac:picMkLst>
        </pc:picChg>
        <pc:picChg chg="del">
          <ac:chgData name="Samantha Smith" userId="46674eb2fb326772" providerId="LiveId" clId="{9E3F6A57-789E-45D1-BCA1-F9DB26406392}" dt="2022-03-31T02:15:10.839" v="962" actId="478"/>
          <ac:picMkLst>
            <pc:docMk/>
            <pc:sldMk cId="3208828586" sldId="270"/>
            <ac:picMk id="3" creationId="{C01EE1E1-CC9E-43BE-85A6-9E7BB449D193}"/>
          </ac:picMkLst>
        </pc:picChg>
        <pc:picChg chg="add del mod">
          <ac:chgData name="Samantha Smith" userId="46674eb2fb326772" providerId="LiveId" clId="{9E3F6A57-789E-45D1-BCA1-F9DB26406392}" dt="2022-03-31T01:57:25.457" v="961" actId="478"/>
          <ac:picMkLst>
            <pc:docMk/>
            <pc:sldMk cId="3208828586" sldId="270"/>
            <ac:picMk id="4" creationId="{687C9D2B-369C-4410-A64D-B95EEB971726}"/>
          </ac:picMkLst>
        </pc:picChg>
        <pc:picChg chg="add del mod">
          <ac:chgData name="Samantha Smith" userId="46674eb2fb326772" providerId="LiveId" clId="{9E3F6A57-789E-45D1-BCA1-F9DB26406392}" dt="2022-04-01T16:05:30.078" v="1086" actId="478"/>
          <ac:picMkLst>
            <pc:docMk/>
            <pc:sldMk cId="3208828586" sldId="270"/>
            <ac:picMk id="6" creationId="{54D232C9-D940-4A84-ACD9-D47AAABCC713}"/>
          </ac:picMkLst>
        </pc:picChg>
        <pc:picChg chg="add mod">
          <ac:chgData name="Samantha Smith" userId="46674eb2fb326772" providerId="LiveId" clId="{9E3F6A57-789E-45D1-BCA1-F9DB26406392}" dt="2022-04-04T21:40:50.978" v="1239" actId="164"/>
          <ac:picMkLst>
            <pc:docMk/>
            <pc:sldMk cId="3208828586" sldId="270"/>
            <ac:picMk id="8" creationId="{89DA148B-3B6A-4C27-9B7A-EE1D64A7B7EE}"/>
          </ac:picMkLst>
        </pc:picChg>
      </pc:sldChg>
      <pc:sldChg chg="addSp delSp modSp mod">
        <pc:chgData name="Samantha Smith" userId="46674eb2fb326772" providerId="LiveId" clId="{9E3F6A57-789E-45D1-BCA1-F9DB26406392}" dt="2022-04-05T16:28:51.984" v="1262" actId="1076"/>
        <pc:sldMkLst>
          <pc:docMk/>
          <pc:sldMk cId="1330710612" sldId="273"/>
        </pc:sldMkLst>
        <pc:picChg chg="add del mod">
          <ac:chgData name="Samantha Smith" userId="46674eb2fb326772" providerId="LiveId" clId="{9E3F6A57-789E-45D1-BCA1-F9DB26406392}" dt="2022-03-31T00:59:15.060" v="874" actId="478"/>
          <ac:picMkLst>
            <pc:docMk/>
            <pc:sldMk cId="1330710612" sldId="273"/>
            <ac:picMk id="3" creationId="{83A1C8AE-DF2B-4229-AB95-B0D1C8717B91}"/>
          </ac:picMkLst>
        </pc:picChg>
        <pc:picChg chg="add mod">
          <ac:chgData name="Samantha Smith" userId="46674eb2fb326772" providerId="LiveId" clId="{9E3F6A57-789E-45D1-BCA1-F9DB26406392}" dt="2022-04-05T16:28:51.984" v="1262" actId="1076"/>
          <ac:picMkLst>
            <pc:docMk/>
            <pc:sldMk cId="1330710612" sldId="273"/>
            <ac:picMk id="3" creationId="{E232C585-5430-4D98-BB0E-9A794E947F70}"/>
          </ac:picMkLst>
        </pc:picChg>
        <pc:picChg chg="add del mod">
          <ac:chgData name="Samantha Smith" userId="46674eb2fb326772" providerId="LiveId" clId="{9E3F6A57-789E-45D1-BCA1-F9DB26406392}" dt="2022-04-05T16:28:07.613" v="1252" actId="478"/>
          <ac:picMkLst>
            <pc:docMk/>
            <pc:sldMk cId="1330710612" sldId="273"/>
            <ac:picMk id="5" creationId="{E572729D-F9C1-4262-916D-7356D68CCD2C}"/>
          </ac:picMkLst>
        </pc:picChg>
      </pc:sldChg>
      <pc:sldChg chg="addSp delSp modSp mod">
        <pc:chgData name="Samantha Smith" userId="46674eb2fb326772" providerId="LiveId" clId="{9E3F6A57-789E-45D1-BCA1-F9DB26406392}" dt="2022-04-04T21:37:27.973" v="1213" actId="1076"/>
        <pc:sldMkLst>
          <pc:docMk/>
          <pc:sldMk cId="27331388" sldId="274"/>
        </pc:sldMkLst>
        <pc:picChg chg="add del mod">
          <ac:chgData name="Samantha Smith" userId="46674eb2fb326772" providerId="LiveId" clId="{9E3F6A57-789E-45D1-BCA1-F9DB26406392}" dt="2022-03-31T01:08:40.868" v="894" actId="478"/>
          <ac:picMkLst>
            <pc:docMk/>
            <pc:sldMk cId="27331388" sldId="274"/>
            <ac:picMk id="3" creationId="{9E3D7801-012A-40E9-B8A0-789015ABF198}"/>
          </ac:picMkLst>
        </pc:picChg>
        <pc:picChg chg="add del mod">
          <ac:chgData name="Samantha Smith" userId="46674eb2fb326772" providerId="LiveId" clId="{9E3F6A57-789E-45D1-BCA1-F9DB26406392}" dt="2022-04-04T21:36:59.988" v="1200" actId="478"/>
          <ac:picMkLst>
            <pc:docMk/>
            <pc:sldMk cId="27331388" sldId="274"/>
            <ac:picMk id="3" creationId="{E573A8FA-5614-488C-9181-1A7DFA280044}"/>
          </ac:picMkLst>
        </pc:picChg>
        <pc:picChg chg="add del mod">
          <ac:chgData name="Samantha Smith" userId="46674eb2fb326772" providerId="LiveId" clId="{9E3F6A57-789E-45D1-BCA1-F9DB26406392}" dt="2022-03-31T14:05:46.772" v="974" actId="478"/>
          <ac:picMkLst>
            <pc:docMk/>
            <pc:sldMk cId="27331388" sldId="274"/>
            <ac:picMk id="5" creationId="{DD85AE10-E92B-4F8C-9289-E1EEC8FD9AE3}"/>
          </ac:picMkLst>
        </pc:picChg>
        <pc:picChg chg="add mod">
          <ac:chgData name="Samantha Smith" userId="46674eb2fb326772" providerId="LiveId" clId="{9E3F6A57-789E-45D1-BCA1-F9DB26406392}" dt="2022-04-04T21:37:27.973" v="1213" actId="1076"/>
          <ac:picMkLst>
            <pc:docMk/>
            <pc:sldMk cId="27331388" sldId="274"/>
            <ac:picMk id="5" creationId="{F288DE53-A019-49D0-95FB-5DC0689BB954}"/>
          </ac:picMkLst>
        </pc:picChg>
        <pc:picChg chg="add del mod">
          <ac:chgData name="Samantha Smith" userId="46674eb2fb326772" providerId="LiveId" clId="{9E3F6A57-789E-45D1-BCA1-F9DB26406392}" dt="2022-03-31T14:10:51.434" v="984" actId="478"/>
          <ac:picMkLst>
            <pc:docMk/>
            <pc:sldMk cId="27331388" sldId="274"/>
            <ac:picMk id="7" creationId="{76B588F7-B43F-4C00-ABE9-A1E7EDC5DF18}"/>
          </ac:picMkLst>
        </pc:picChg>
        <pc:picChg chg="add del mod">
          <ac:chgData name="Samantha Smith" userId="46674eb2fb326772" providerId="LiveId" clId="{9E3F6A57-789E-45D1-BCA1-F9DB26406392}" dt="2022-03-31T14:26:01.204" v="1004" actId="478"/>
          <ac:picMkLst>
            <pc:docMk/>
            <pc:sldMk cId="27331388" sldId="274"/>
            <ac:picMk id="9" creationId="{AC6A4473-2962-4883-B0AE-C9570793C16D}"/>
          </ac:picMkLst>
        </pc:picChg>
        <pc:picChg chg="add del mod">
          <ac:chgData name="Samantha Smith" userId="46674eb2fb326772" providerId="LiveId" clId="{9E3F6A57-789E-45D1-BCA1-F9DB26406392}" dt="2022-04-01T15:57:49.629" v="1054" actId="478"/>
          <ac:picMkLst>
            <pc:docMk/>
            <pc:sldMk cId="27331388" sldId="274"/>
            <ac:picMk id="11" creationId="{E652ABFD-A2D7-4F60-B8AA-3E8F15CB9627}"/>
          </ac:picMkLst>
        </pc:picChg>
      </pc:sldChg>
      <pc:sldChg chg="addSp delSp modSp mod">
        <pc:chgData name="Samantha Smith" userId="46674eb2fb326772" providerId="LiveId" clId="{9E3F6A57-789E-45D1-BCA1-F9DB26406392}" dt="2022-04-05T16:22:57.921" v="1251" actId="1076"/>
        <pc:sldMkLst>
          <pc:docMk/>
          <pc:sldMk cId="4136026996" sldId="275"/>
        </pc:sldMkLst>
        <pc:picChg chg="add del mod">
          <ac:chgData name="Samantha Smith" userId="46674eb2fb326772" providerId="LiveId" clId="{9E3F6A57-789E-45D1-BCA1-F9DB26406392}" dt="2022-04-05T16:22:39.289" v="1242" actId="478"/>
          <ac:picMkLst>
            <pc:docMk/>
            <pc:sldMk cId="4136026996" sldId="275"/>
            <ac:picMk id="3" creationId="{80DED0B4-12E6-4CEB-BC09-6162246A24F0}"/>
          </ac:picMkLst>
        </pc:picChg>
        <pc:picChg chg="add mod">
          <ac:chgData name="Samantha Smith" userId="46674eb2fb326772" providerId="LiveId" clId="{9E3F6A57-789E-45D1-BCA1-F9DB26406392}" dt="2022-04-05T16:22:57.921" v="1251" actId="1076"/>
          <ac:picMkLst>
            <pc:docMk/>
            <pc:sldMk cId="4136026996" sldId="275"/>
            <ac:picMk id="4" creationId="{F7EAD606-E83D-4103-82F7-484A63A61A94}"/>
          </ac:picMkLst>
        </pc:picChg>
        <pc:picChg chg="del">
          <ac:chgData name="Samantha Smith" userId="46674eb2fb326772" providerId="LiveId" clId="{9E3F6A57-789E-45D1-BCA1-F9DB26406392}" dt="2022-03-31T01:10:15.928" v="907" actId="478"/>
          <ac:picMkLst>
            <pc:docMk/>
            <pc:sldMk cId="4136026996" sldId="275"/>
            <ac:picMk id="7" creationId="{D991BD0B-B12F-4102-9D14-E986BD2C5EDF}"/>
          </ac:picMkLst>
        </pc:picChg>
      </pc:sldChg>
      <pc:sldChg chg="addSp delSp modSp new mod">
        <pc:chgData name="Samantha Smith" userId="46674eb2fb326772" providerId="LiveId" clId="{9E3F6A57-789E-45D1-BCA1-F9DB26406392}" dt="2022-04-04T21:38:53.062" v="1225" actId="1076"/>
        <pc:sldMkLst>
          <pc:docMk/>
          <pc:sldMk cId="1572044156" sldId="276"/>
        </pc:sldMkLst>
        <pc:spChg chg="del">
          <ac:chgData name="Samantha Smith" userId="46674eb2fb326772" providerId="LiveId" clId="{9E3F6A57-789E-45D1-BCA1-F9DB26406392}" dt="2022-03-31T01:09:25.055" v="906" actId="478"/>
          <ac:spMkLst>
            <pc:docMk/>
            <pc:sldMk cId="1572044156" sldId="276"/>
            <ac:spMk id="2" creationId="{E7C8B478-294E-4A49-8CA0-CEFE060E406E}"/>
          </ac:spMkLst>
        </pc:spChg>
        <pc:spChg chg="del">
          <ac:chgData name="Samantha Smith" userId="46674eb2fb326772" providerId="LiveId" clId="{9E3F6A57-789E-45D1-BCA1-F9DB26406392}" dt="2022-03-31T01:09:24.483" v="905" actId="478"/>
          <ac:spMkLst>
            <pc:docMk/>
            <pc:sldMk cId="1572044156" sldId="276"/>
            <ac:spMk id="3" creationId="{B6557E16-826C-4B37-8FEB-D1FAB3582E35}"/>
          </ac:spMkLst>
        </pc:spChg>
        <pc:picChg chg="add del mod">
          <ac:chgData name="Samantha Smith" userId="46674eb2fb326772" providerId="LiveId" clId="{9E3F6A57-789E-45D1-BCA1-F9DB26406392}" dt="2022-04-01T15:59:48.607" v="1073" actId="478"/>
          <ac:picMkLst>
            <pc:docMk/>
            <pc:sldMk cId="1572044156" sldId="276"/>
            <ac:picMk id="3" creationId="{04ECE346-F0F7-43AF-8EF4-C8DF78E86A63}"/>
          </ac:picMkLst>
        </pc:picChg>
        <pc:picChg chg="add del mod">
          <ac:chgData name="Samantha Smith" userId="46674eb2fb326772" providerId="LiveId" clId="{9E3F6A57-789E-45D1-BCA1-F9DB26406392}" dt="2022-04-04T21:37:31.141" v="1214" actId="478"/>
          <ac:picMkLst>
            <pc:docMk/>
            <pc:sldMk cId="1572044156" sldId="276"/>
            <ac:picMk id="5" creationId="{7EEAE3F2-0B47-4E5C-8F47-3E311EF32502}"/>
          </ac:picMkLst>
        </pc:picChg>
        <pc:picChg chg="add del mod">
          <ac:chgData name="Samantha Smith" userId="46674eb2fb326772" providerId="LiveId" clId="{9E3F6A57-789E-45D1-BCA1-F9DB26406392}" dt="2022-03-31T01:31:25.731" v="925" actId="478"/>
          <ac:picMkLst>
            <pc:docMk/>
            <pc:sldMk cId="1572044156" sldId="276"/>
            <ac:picMk id="5" creationId="{D74CA034-0F65-4B6F-93F7-80641DED2725}"/>
          </ac:picMkLst>
        </pc:picChg>
        <pc:picChg chg="add del mod">
          <ac:chgData name="Samantha Smith" userId="46674eb2fb326772" providerId="LiveId" clId="{9E3F6A57-789E-45D1-BCA1-F9DB26406392}" dt="2022-03-31T14:12:32.886" v="993" actId="478"/>
          <ac:picMkLst>
            <pc:docMk/>
            <pc:sldMk cId="1572044156" sldId="276"/>
            <ac:picMk id="7" creationId="{59650913-5D43-4AB5-9312-746A155DD5AF}"/>
          </ac:picMkLst>
        </pc:picChg>
        <pc:picChg chg="add mod">
          <ac:chgData name="Samantha Smith" userId="46674eb2fb326772" providerId="LiveId" clId="{9E3F6A57-789E-45D1-BCA1-F9DB26406392}" dt="2022-04-04T21:38:53.062" v="1225" actId="1076"/>
          <ac:picMkLst>
            <pc:docMk/>
            <pc:sldMk cId="1572044156" sldId="276"/>
            <ac:picMk id="7" creationId="{7082B5F9-741B-4734-BF37-F3471A3E6DF9}"/>
          </ac:picMkLst>
        </pc:picChg>
        <pc:picChg chg="add del mod">
          <ac:chgData name="Samantha Smith" userId="46674eb2fb326772" providerId="LiveId" clId="{9E3F6A57-789E-45D1-BCA1-F9DB26406392}" dt="2022-03-31T14:25:59.304" v="1003" actId="478"/>
          <ac:picMkLst>
            <pc:docMk/>
            <pc:sldMk cId="1572044156" sldId="276"/>
            <ac:picMk id="9" creationId="{8D922071-CE1B-4BD9-9084-17C2EEB79C6D}"/>
          </ac:picMkLst>
        </pc:picChg>
        <pc:picChg chg="add del mod">
          <ac:chgData name="Samantha Smith" userId="46674eb2fb326772" providerId="LiveId" clId="{9E3F6A57-789E-45D1-BCA1-F9DB26406392}" dt="2022-04-01T15:57:50.886" v="1055" actId="478"/>
          <ac:picMkLst>
            <pc:docMk/>
            <pc:sldMk cId="1572044156" sldId="276"/>
            <ac:picMk id="11" creationId="{CFF1749A-49AA-46C8-8AFA-62618F24F9D7}"/>
          </ac:picMkLst>
        </pc:picChg>
      </pc:sldChg>
      <pc:sldChg chg="addSp delSp modSp new mod">
        <pc:chgData name="Samantha Smith" userId="46674eb2fb326772" providerId="LiveId" clId="{9E3F6A57-789E-45D1-BCA1-F9DB26406392}" dt="2022-03-31T17:57:33.409" v="1051" actId="1076"/>
        <pc:sldMkLst>
          <pc:docMk/>
          <pc:sldMk cId="2311578382" sldId="277"/>
        </pc:sldMkLst>
        <pc:spChg chg="del mod">
          <ac:chgData name="Samantha Smith" userId="46674eb2fb326772" providerId="LiveId" clId="{9E3F6A57-789E-45D1-BCA1-F9DB26406392}" dt="2022-03-31T01:35:33.454" v="937" actId="478"/>
          <ac:spMkLst>
            <pc:docMk/>
            <pc:sldMk cId="2311578382" sldId="277"/>
            <ac:spMk id="2" creationId="{A503F14D-7398-4272-805B-1DF25D70168F}"/>
          </ac:spMkLst>
        </pc:spChg>
        <pc:spChg chg="del mod">
          <ac:chgData name="Samantha Smith" userId="46674eb2fb326772" providerId="LiveId" clId="{9E3F6A57-789E-45D1-BCA1-F9DB26406392}" dt="2022-03-31T01:35:34.077" v="939" actId="478"/>
          <ac:spMkLst>
            <pc:docMk/>
            <pc:sldMk cId="2311578382" sldId="277"/>
            <ac:spMk id="3" creationId="{778C8BDE-BB3A-4D7D-AC3A-C5DA8116F05A}"/>
          </ac:spMkLst>
        </pc:spChg>
        <pc:picChg chg="add mod modCrop">
          <ac:chgData name="Samantha Smith" userId="46674eb2fb326772" providerId="LiveId" clId="{9E3F6A57-789E-45D1-BCA1-F9DB26406392}" dt="2022-03-31T17:57:33.409" v="1051" actId="1076"/>
          <ac:picMkLst>
            <pc:docMk/>
            <pc:sldMk cId="2311578382" sldId="277"/>
            <ac:picMk id="5" creationId="{7FFD76F5-F1B5-4EB3-BF4B-D07017DD202A}"/>
          </ac:picMkLst>
        </pc:picChg>
      </pc:sldChg>
      <pc:sldChg chg="addSp delSp modSp new mod">
        <pc:chgData name="Samantha Smith" userId="46674eb2fb326772" providerId="LiveId" clId="{9E3F6A57-789E-45D1-BCA1-F9DB26406392}" dt="2022-04-01T16:33:10.417" v="1192" actId="1076"/>
        <pc:sldMkLst>
          <pc:docMk/>
          <pc:sldMk cId="2617572733" sldId="278"/>
        </pc:sldMkLst>
        <pc:spChg chg="del">
          <ac:chgData name="Samantha Smith" userId="46674eb2fb326772" providerId="LiveId" clId="{9E3F6A57-789E-45D1-BCA1-F9DB26406392}" dt="2022-03-31T17:56:23.457" v="1026" actId="478"/>
          <ac:spMkLst>
            <pc:docMk/>
            <pc:sldMk cId="2617572733" sldId="278"/>
            <ac:spMk id="2" creationId="{E312283F-F36B-4940-BF26-889C3AA96F12}"/>
          </ac:spMkLst>
        </pc:spChg>
        <pc:spChg chg="del">
          <ac:chgData name="Samantha Smith" userId="46674eb2fb326772" providerId="LiveId" clId="{9E3F6A57-789E-45D1-BCA1-F9DB26406392}" dt="2022-03-31T17:56:23.076" v="1025" actId="478"/>
          <ac:spMkLst>
            <pc:docMk/>
            <pc:sldMk cId="2617572733" sldId="278"/>
            <ac:spMk id="3" creationId="{7B3E2A13-F1F0-4D68-873B-7A90947F435E}"/>
          </ac:spMkLst>
        </pc:spChg>
        <pc:spChg chg="add del mod">
          <ac:chgData name="Samantha Smith" userId="46674eb2fb326772" providerId="LiveId" clId="{9E3F6A57-789E-45D1-BCA1-F9DB26406392}" dt="2022-04-01T16:09:25.115" v="1125"/>
          <ac:spMkLst>
            <pc:docMk/>
            <pc:sldMk cId="2617572733" sldId="278"/>
            <ac:spMk id="3" creationId="{F3978AC1-696C-47D9-BAC6-414DC6B5994F}"/>
          </ac:spMkLst>
        </pc:spChg>
        <pc:spChg chg="add mod">
          <ac:chgData name="Samantha Smith" userId="46674eb2fb326772" providerId="LiveId" clId="{9E3F6A57-789E-45D1-BCA1-F9DB26406392}" dt="2022-03-31T17:56:24.609" v="1028" actId="113"/>
          <ac:spMkLst>
            <pc:docMk/>
            <pc:sldMk cId="2617572733" sldId="278"/>
            <ac:spMk id="5" creationId="{C938CEE3-7C08-4A1E-BF96-E70B7ECB923A}"/>
          </ac:spMkLst>
        </pc:spChg>
        <pc:spChg chg="add mod">
          <ac:chgData name="Samantha Smith" userId="46674eb2fb326772" providerId="LiveId" clId="{9E3F6A57-789E-45D1-BCA1-F9DB26406392}" dt="2022-04-01T16:09:25.296" v="1126"/>
          <ac:spMkLst>
            <pc:docMk/>
            <pc:sldMk cId="2617572733" sldId="278"/>
            <ac:spMk id="7" creationId="{38D1EC65-96CF-4710-B811-A44A8C627A99}"/>
          </ac:spMkLst>
        </pc:spChg>
        <pc:graphicFrameChg chg="add del mod">
          <ac:chgData name="Samantha Smith" userId="46674eb2fb326772" providerId="LiveId" clId="{9E3F6A57-789E-45D1-BCA1-F9DB26406392}" dt="2022-04-01T16:09:25.115" v="1125"/>
          <ac:graphicFrameMkLst>
            <pc:docMk/>
            <pc:sldMk cId="2617572733" sldId="278"/>
            <ac:graphicFrameMk id="2" creationId="{B3815E8E-07EE-4B83-9A23-F57A105D0E36}"/>
          </ac:graphicFrameMkLst>
        </pc:graphicFrameChg>
        <pc:graphicFrameChg chg="add mod modGraphic">
          <ac:chgData name="Samantha Smith" userId="46674eb2fb326772" providerId="LiveId" clId="{9E3F6A57-789E-45D1-BCA1-F9DB26406392}" dt="2022-04-01T16:33:10.417" v="1192" actId="1076"/>
          <ac:graphicFrameMkLst>
            <pc:docMk/>
            <pc:sldMk cId="2617572733" sldId="278"/>
            <ac:graphicFrameMk id="4" creationId="{D25EF946-23BB-42DB-B319-C7959DC6FB21}"/>
          </ac:graphicFrameMkLst>
        </pc:graphicFrameChg>
        <pc:graphicFrameChg chg="add del mod">
          <ac:chgData name="Samantha Smith" userId="46674eb2fb326772" providerId="LiveId" clId="{9E3F6A57-789E-45D1-BCA1-F9DB26406392}" dt="2022-03-31T17:56:40.490" v="1031" actId="478"/>
          <ac:graphicFrameMkLst>
            <pc:docMk/>
            <pc:sldMk cId="2617572733" sldId="278"/>
            <ac:graphicFrameMk id="4" creationId="{E2D13641-285F-4CBD-87E7-66ED35D04BA5}"/>
          </ac:graphicFrameMkLst>
        </pc:graphicFrameChg>
        <pc:picChg chg="add del mod">
          <ac:chgData name="Samantha Smith" userId="46674eb2fb326772" providerId="LiveId" clId="{9E3F6A57-789E-45D1-BCA1-F9DB26406392}" dt="2022-04-01T16:09:27.387" v="1127" actId="478"/>
          <ac:picMkLst>
            <pc:docMk/>
            <pc:sldMk cId="2617572733" sldId="278"/>
            <ac:picMk id="6" creationId="{829726A8-9431-49BB-922D-B53580EFE322}"/>
          </ac:picMkLst>
        </pc:picChg>
      </pc:sldChg>
      <pc:sldChg chg="addSp delSp modSp new mod addCm">
        <pc:chgData name="Samantha Smith" userId="46674eb2fb326772" providerId="LiveId" clId="{9E3F6A57-789E-45D1-BCA1-F9DB26406392}" dt="2022-04-04T21:39:09.784" v="1226" actId="1076"/>
        <pc:sldMkLst>
          <pc:docMk/>
          <pc:sldMk cId="885387492" sldId="279"/>
        </pc:sldMkLst>
        <pc:spChg chg="del">
          <ac:chgData name="Samantha Smith" userId="46674eb2fb326772" providerId="LiveId" clId="{9E3F6A57-789E-45D1-BCA1-F9DB26406392}" dt="2022-03-31T17:56:54.353" v="1036" actId="478"/>
          <ac:spMkLst>
            <pc:docMk/>
            <pc:sldMk cId="885387492" sldId="279"/>
            <ac:spMk id="2" creationId="{CF7A11FE-FC50-4F17-9C75-CFC341795653}"/>
          </ac:spMkLst>
        </pc:spChg>
        <pc:spChg chg="del">
          <ac:chgData name="Samantha Smith" userId="46674eb2fb326772" providerId="LiveId" clId="{9E3F6A57-789E-45D1-BCA1-F9DB26406392}" dt="2022-03-31T17:56:53.921" v="1035" actId="478"/>
          <ac:spMkLst>
            <pc:docMk/>
            <pc:sldMk cId="885387492" sldId="279"/>
            <ac:spMk id="3" creationId="{8AAB981B-1393-46EA-944F-1DBCD529DCFA}"/>
          </ac:spMkLst>
        </pc:spChg>
        <pc:spChg chg="add del mod">
          <ac:chgData name="Samantha Smith" userId="46674eb2fb326772" providerId="LiveId" clId="{9E3F6A57-789E-45D1-BCA1-F9DB26406392}" dt="2022-03-31T17:57:06.965" v="1038"/>
          <ac:spMkLst>
            <pc:docMk/>
            <pc:sldMk cId="885387492" sldId="279"/>
            <ac:spMk id="5" creationId="{6F1FD5C1-463E-4DA5-BD10-94579780088A}"/>
          </ac:spMkLst>
        </pc:spChg>
        <pc:spChg chg="add del">
          <ac:chgData name="Samantha Smith" userId="46674eb2fb326772" providerId="LiveId" clId="{9E3F6A57-789E-45D1-BCA1-F9DB26406392}" dt="2022-03-31T17:57:08.914" v="1041" actId="22"/>
          <ac:spMkLst>
            <pc:docMk/>
            <pc:sldMk cId="885387492" sldId="279"/>
            <ac:spMk id="7" creationId="{CE983E36-DBE4-431E-A04D-3FBB3759B528}"/>
          </ac:spMkLst>
        </pc:spChg>
        <pc:graphicFrameChg chg="add del mod">
          <ac:chgData name="Samantha Smith" userId="46674eb2fb326772" providerId="LiveId" clId="{9E3F6A57-789E-45D1-BCA1-F9DB26406392}" dt="2022-04-01T16:08:48.347" v="1106"/>
          <ac:graphicFrameMkLst>
            <pc:docMk/>
            <pc:sldMk cId="885387492" sldId="279"/>
            <ac:graphicFrameMk id="2" creationId="{74A46D16-FBCB-40C9-883E-77046D50EFAB}"/>
          </ac:graphicFrameMkLst>
        </pc:graphicFrameChg>
        <pc:graphicFrameChg chg="add mod">
          <ac:chgData name="Samantha Smith" userId="46674eb2fb326772" providerId="LiveId" clId="{9E3F6A57-789E-45D1-BCA1-F9DB26406392}" dt="2022-04-04T21:39:09.784" v="1226" actId="1076"/>
          <ac:graphicFrameMkLst>
            <pc:docMk/>
            <pc:sldMk cId="885387492" sldId="279"/>
            <ac:graphicFrameMk id="3" creationId="{86B9E833-F7DC-4F2F-B36C-DB7F4F98244B}"/>
          </ac:graphicFrameMkLst>
        </pc:graphicFrameChg>
        <pc:graphicFrameChg chg="add del mod">
          <ac:chgData name="Samantha Smith" userId="46674eb2fb326772" providerId="LiveId" clId="{9E3F6A57-789E-45D1-BCA1-F9DB26406392}" dt="2022-03-31T17:57:06.965" v="1038"/>
          <ac:graphicFrameMkLst>
            <pc:docMk/>
            <pc:sldMk cId="885387492" sldId="279"/>
            <ac:graphicFrameMk id="4" creationId="{E0BBDD48-D85F-4E0C-8746-C1753E865961}"/>
          </ac:graphicFrameMkLst>
        </pc:graphicFrameChg>
        <pc:picChg chg="add del mod">
          <ac:chgData name="Samantha Smith" userId="46674eb2fb326772" providerId="LiveId" clId="{9E3F6A57-789E-45D1-BCA1-F9DB26406392}" dt="2022-04-01T16:08:58.134" v="1114" actId="478"/>
          <ac:picMkLst>
            <pc:docMk/>
            <pc:sldMk cId="885387492" sldId="279"/>
            <ac:picMk id="8" creationId="{74AED1AC-8FD9-4F29-83D4-3F83111D92BC}"/>
          </ac:picMkLst>
        </pc:picChg>
      </pc:sldChg>
      <pc:sldMasterChg chg="modSp modSldLayout">
        <pc:chgData name="Samantha Smith" userId="46674eb2fb326772" providerId="LiveId" clId="{9E3F6A57-789E-45D1-BCA1-F9DB26406392}" dt="2022-03-16T02:11:27.130" v="590"/>
        <pc:sldMasterMkLst>
          <pc:docMk/>
          <pc:sldMasterMk cId="4101904177" sldId="2147483672"/>
        </pc:sldMasterMkLst>
        <pc:spChg chg="mod">
          <ac:chgData name="Samantha Smith" userId="46674eb2fb326772" providerId="LiveId" clId="{9E3F6A57-789E-45D1-BCA1-F9DB26406392}" dt="2022-03-16T02:11:27.130" v="590"/>
          <ac:spMkLst>
            <pc:docMk/>
            <pc:sldMasterMk cId="4101904177" sldId="2147483672"/>
            <ac:spMk id="2" creationId="{00000000-0000-0000-0000-000000000000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asterMk cId="4101904177" sldId="2147483672"/>
            <ac:spMk id="3" creationId="{00000000-0000-0000-0000-000000000000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asterMk cId="4101904177" sldId="2147483672"/>
            <ac:spMk id="4" creationId="{00000000-0000-0000-0000-000000000000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asterMk cId="4101904177" sldId="2147483672"/>
            <ac:spMk id="5" creationId="{00000000-0000-0000-0000-000000000000}"/>
          </ac:spMkLst>
        </pc:spChg>
        <pc:spChg chg="mod">
          <ac:chgData name="Samantha Smith" userId="46674eb2fb326772" providerId="LiveId" clId="{9E3F6A57-789E-45D1-BCA1-F9DB26406392}" dt="2022-03-16T02:11:27.130" v="590"/>
          <ac:spMkLst>
            <pc:docMk/>
            <pc:sldMasterMk cId="4101904177" sldId="2147483672"/>
            <ac:spMk id="6" creationId="{00000000-0000-0000-0000-000000000000}"/>
          </ac:spMkLst>
        </pc:spChg>
        <pc:sldLayoutChg chg="modSp">
          <pc:chgData name="Samantha Smith" userId="46674eb2fb326772" providerId="LiveId" clId="{9E3F6A57-789E-45D1-BCA1-F9DB26406392}" dt="2022-03-16T02:11:27.130" v="590"/>
          <pc:sldLayoutMkLst>
            <pc:docMk/>
            <pc:sldMasterMk cId="4101904177" sldId="2147483672"/>
            <pc:sldLayoutMk cId="1235587711" sldId="2147483673"/>
          </pc:sldLayoutMkLst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1235587711" sldId="2147483673"/>
              <ac:spMk id="2" creationId="{00000000-0000-0000-0000-000000000000}"/>
            </ac:spMkLst>
          </pc:spChg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1235587711" sldId="2147483673"/>
              <ac:spMk id="3" creationId="{00000000-0000-0000-0000-000000000000}"/>
            </ac:spMkLst>
          </pc:spChg>
        </pc:sldLayoutChg>
        <pc:sldLayoutChg chg="modSp">
          <pc:chgData name="Samantha Smith" userId="46674eb2fb326772" providerId="LiveId" clId="{9E3F6A57-789E-45D1-BCA1-F9DB26406392}" dt="2022-03-16T02:11:27.130" v="590"/>
          <pc:sldLayoutMkLst>
            <pc:docMk/>
            <pc:sldMasterMk cId="4101904177" sldId="2147483672"/>
            <pc:sldLayoutMk cId="2629926177" sldId="2147483675"/>
          </pc:sldLayoutMkLst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2629926177" sldId="2147483675"/>
              <ac:spMk id="2" creationId="{00000000-0000-0000-0000-000000000000}"/>
            </ac:spMkLst>
          </pc:spChg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2629926177" sldId="2147483675"/>
              <ac:spMk id="3" creationId="{00000000-0000-0000-0000-000000000000}"/>
            </ac:spMkLst>
          </pc:spChg>
        </pc:sldLayoutChg>
        <pc:sldLayoutChg chg="modSp">
          <pc:chgData name="Samantha Smith" userId="46674eb2fb326772" providerId="LiveId" clId="{9E3F6A57-789E-45D1-BCA1-F9DB26406392}" dt="2022-03-16T02:11:27.130" v="590"/>
          <pc:sldLayoutMkLst>
            <pc:docMk/>
            <pc:sldMasterMk cId="4101904177" sldId="2147483672"/>
            <pc:sldLayoutMk cId="2861344724" sldId="2147483676"/>
          </pc:sldLayoutMkLst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2861344724" sldId="2147483676"/>
              <ac:spMk id="3" creationId="{00000000-0000-0000-0000-000000000000}"/>
            </ac:spMkLst>
          </pc:spChg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2861344724" sldId="2147483676"/>
              <ac:spMk id="4" creationId="{00000000-0000-0000-0000-000000000000}"/>
            </ac:spMkLst>
          </pc:spChg>
        </pc:sldLayoutChg>
        <pc:sldLayoutChg chg="modSp">
          <pc:chgData name="Samantha Smith" userId="46674eb2fb326772" providerId="LiveId" clId="{9E3F6A57-789E-45D1-BCA1-F9DB26406392}" dt="2022-03-16T02:11:27.130" v="590"/>
          <pc:sldLayoutMkLst>
            <pc:docMk/>
            <pc:sldMasterMk cId="4101904177" sldId="2147483672"/>
            <pc:sldLayoutMk cId="4093951030" sldId="2147483677"/>
          </pc:sldLayoutMkLst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4093951030" sldId="2147483677"/>
              <ac:spMk id="2" creationId="{00000000-0000-0000-0000-000000000000}"/>
            </ac:spMkLst>
          </pc:spChg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4093951030" sldId="2147483677"/>
              <ac:spMk id="3" creationId="{00000000-0000-0000-0000-000000000000}"/>
            </ac:spMkLst>
          </pc:spChg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4093951030" sldId="2147483677"/>
              <ac:spMk id="4" creationId="{00000000-0000-0000-0000-000000000000}"/>
            </ac:spMkLst>
          </pc:spChg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4093951030" sldId="2147483677"/>
              <ac:spMk id="5" creationId="{00000000-0000-0000-0000-000000000000}"/>
            </ac:spMkLst>
          </pc:spChg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4093951030" sldId="2147483677"/>
              <ac:spMk id="6" creationId="{00000000-0000-0000-0000-000000000000}"/>
            </ac:spMkLst>
          </pc:spChg>
        </pc:sldLayoutChg>
        <pc:sldLayoutChg chg="modSp">
          <pc:chgData name="Samantha Smith" userId="46674eb2fb326772" providerId="LiveId" clId="{9E3F6A57-789E-45D1-BCA1-F9DB26406392}" dt="2022-03-16T02:11:27.130" v="590"/>
          <pc:sldLayoutMkLst>
            <pc:docMk/>
            <pc:sldMasterMk cId="4101904177" sldId="2147483672"/>
            <pc:sldLayoutMk cId="1105462476" sldId="2147483680"/>
          </pc:sldLayoutMkLst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1105462476" sldId="2147483680"/>
              <ac:spMk id="2" creationId="{00000000-0000-0000-0000-000000000000}"/>
            </ac:spMkLst>
          </pc:spChg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1105462476" sldId="2147483680"/>
              <ac:spMk id="3" creationId="{00000000-0000-0000-0000-000000000000}"/>
            </ac:spMkLst>
          </pc:spChg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1105462476" sldId="2147483680"/>
              <ac:spMk id="4" creationId="{00000000-0000-0000-0000-000000000000}"/>
            </ac:spMkLst>
          </pc:spChg>
        </pc:sldLayoutChg>
        <pc:sldLayoutChg chg="modSp">
          <pc:chgData name="Samantha Smith" userId="46674eb2fb326772" providerId="LiveId" clId="{9E3F6A57-789E-45D1-BCA1-F9DB26406392}" dt="2022-03-16T02:11:27.130" v="590"/>
          <pc:sldLayoutMkLst>
            <pc:docMk/>
            <pc:sldMasterMk cId="4101904177" sldId="2147483672"/>
            <pc:sldLayoutMk cId="3694869984" sldId="2147483681"/>
          </pc:sldLayoutMkLst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3694869984" sldId="2147483681"/>
              <ac:spMk id="2" creationId="{00000000-0000-0000-0000-000000000000}"/>
            </ac:spMkLst>
          </pc:spChg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3694869984" sldId="2147483681"/>
              <ac:spMk id="3" creationId="{00000000-0000-0000-0000-000000000000}"/>
            </ac:spMkLst>
          </pc:spChg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3694869984" sldId="2147483681"/>
              <ac:spMk id="4" creationId="{00000000-0000-0000-0000-000000000000}"/>
            </ac:spMkLst>
          </pc:spChg>
        </pc:sldLayoutChg>
        <pc:sldLayoutChg chg="modSp">
          <pc:chgData name="Samantha Smith" userId="46674eb2fb326772" providerId="LiveId" clId="{9E3F6A57-789E-45D1-BCA1-F9DB26406392}" dt="2022-03-16T02:11:27.130" v="590"/>
          <pc:sldLayoutMkLst>
            <pc:docMk/>
            <pc:sldMasterMk cId="4101904177" sldId="2147483672"/>
            <pc:sldLayoutMk cId="3118734119" sldId="2147483683"/>
          </pc:sldLayoutMkLst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3118734119" sldId="2147483683"/>
              <ac:spMk id="2" creationId="{00000000-0000-0000-0000-000000000000}"/>
            </ac:spMkLst>
          </pc:spChg>
          <pc:spChg chg="mod">
            <ac:chgData name="Samantha Smith" userId="46674eb2fb326772" providerId="LiveId" clId="{9E3F6A57-789E-45D1-BCA1-F9DB26406392}" dt="2022-03-16T02:11:27.130" v="590"/>
            <ac:spMkLst>
              <pc:docMk/>
              <pc:sldMasterMk cId="4101904177" sldId="2147483672"/>
              <pc:sldLayoutMk cId="3118734119" sldId="2147483683"/>
              <ac:spMk id="3" creationId="{00000000-0000-0000-0000-000000000000}"/>
            </ac:spMkLst>
          </pc:spChg>
        </pc:sldLayoutChg>
      </pc:sldMasterChg>
    </pc:docChg>
  </pc:docChgLst>
</pc:chgInfo>
</file>

<file path=ppt/comments/modernComment_117_34C5F0E4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8DD54EAD-ED61-48A7-8832-5FF573A52AA5}" authorId="{E396A35B-DC08-809C-A6F2-9C2BFEDCBFC3}" created="2022-04-01T16:53:32.110">
    <pc:sldMkLst xmlns:pc="http://schemas.microsoft.com/office/powerpoint/2013/main/command">
      <pc:docMk/>
      <pc:sldMk cId="885387492" sldId="279"/>
    </pc:sldMkLst>
    <p188:txBody>
      <a:bodyPr/>
      <a:lstStyle/>
      <a:p>
        <a:r>
          <a:rPr lang="en-US"/>
          <a:t>*Embedded to word*</a:t>
        </a:r>
      </a:p>
    </p188:txBody>
  </p188:cm>
</p188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F3E2F-ADAB-4ECF-BC60-6EDD33F11359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E800DE-9F46-4165-BE88-8A07D1ED7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786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F3E2F-ADAB-4ECF-BC60-6EDD33F11359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E800DE-9F46-4165-BE88-8A07D1ED7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9448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F3E2F-ADAB-4ECF-BC60-6EDD33F11359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E800DE-9F46-4165-BE88-8A07D1ED7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573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F3E2F-ADAB-4ECF-BC60-6EDD33F11359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E800DE-9F46-4165-BE88-8A07D1ED7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579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F3E2F-ADAB-4ECF-BC60-6EDD33F11359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E800DE-9F46-4165-BE88-8A07D1ED7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552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F3E2F-ADAB-4ECF-BC60-6EDD33F11359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E800DE-9F46-4165-BE88-8A07D1ED7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983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F3E2F-ADAB-4ECF-BC60-6EDD33F11359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E800DE-9F46-4165-BE88-8A07D1ED7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503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F3E2F-ADAB-4ECF-BC60-6EDD33F11359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E800DE-9F46-4165-BE88-8A07D1ED7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7278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F3E2F-ADAB-4ECF-BC60-6EDD33F11359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E800DE-9F46-4165-BE88-8A07D1ED7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08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F3E2F-ADAB-4ECF-BC60-6EDD33F11359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E800DE-9F46-4165-BE88-8A07D1ED7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718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F3E2F-ADAB-4ECF-BC60-6EDD33F11359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E800DE-9F46-4165-BE88-8A07D1ED7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6354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5F3E2F-ADAB-4ECF-BC60-6EDD33F11359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E800DE-9F46-4165-BE88-8A07D1ED7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72151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Word_Document.docx"/><Relationship Id="rId2" Type="http://schemas.microsoft.com/office/2018/10/relationships/comments" Target="../comments/modernComment_117_34C5F0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w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F7EAD606-E83D-4103-82F7-484A63A61A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401" y="-48882"/>
            <a:ext cx="7488999" cy="96916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60269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6B9E833-F7DC-4F2F-B36C-DB7F4F98244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621293"/>
              </p:ext>
            </p:extLst>
          </p:nvPr>
        </p:nvGraphicFramePr>
        <p:xfrm>
          <a:off x="297656" y="1766888"/>
          <a:ext cx="7177087" cy="4029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Document" r:id="rId3" imgW="6320880" imgH="3548160" progId="Word.Document.12">
                  <p:embed/>
                </p:oleObj>
              </mc:Choice>
              <mc:Fallback>
                <p:oleObj name="Document" r:id="rId3" imgW="6320880" imgH="3548160" progId="Word.Document.12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6B9E833-F7DC-4F2F-B36C-DB7F4F98244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7656" y="1766888"/>
                        <a:ext cx="7177087" cy="4029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85387492"/>
      </p:ext>
    </p:extLst>
  </p:cSld>
  <p:clrMapOvr>
    <a:masterClrMapping/>
  </p:clrMapOvr>
  <p:extLst>
    <p:ext uri="{6950BFC3-D8DA-4A85-94F7-54DA5524770B}">
      <p188:commentRel xmlns:p188="http://schemas.microsoft.com/office/powerpoint/2018/8/main" r:id="rId2"/>
    </p:ext>
  </p:extLs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CDF6BC61-1B45-4E0B-8F8B-D38E2CDCE16B}"/>
              </a:ext>
            </a:extLst>
          </p:cNvPr>
          <p:cNvGrpSpPr/>
          <p:nvPr/>
        </p:nvGrpSpPr>
        <p:grpSpPr>
          <a:xfrm>
            <a:off x="336642" y="144380"/>
            <a:ext cx="7339505" cy="9432757"/>
            <a:chOff x="583290" y="144380"/>
            <a:chExt cx="6761990" cy="8750809"/>
          </a:xfrm>
        </p:grpSpPr>
        <p:pic>
          <p:nvPicPr>
            <p:cNvPr id="8" name="Picture 7" descr="A picture containing graphical user interface&#10;&#10;Description automatically generated">
              <a:extLst>
                <a:ext uri="{FF2B5EF4-FFF2-40B4-BE49-F238E27FC236}">
                  <a16:creationId xmlns:a16="http://schemas.microsoft.com/office/drawing/2014/main" id="{89DA148B-3B6A-4C27-9B7A-EE1D64A7B7E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3290" y="144380"/>
              <a:ext cx="6761990" cy="8750809"/>
            </a:xfrm>
            <a:prstGeom prst="rect">
              <a:avLst/>
            </a:prstGeom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A077A390-5292-45C9-8272-54437143946B}"/>
                </a:ext>
              </a:extLst>
            </p:cNvPr>
            <p:cNvSpPr/>
            <p:nvPr/>
          </p:nvSpPr>
          <p:spPr>
            <a:xfrm>
              <a:off x="980574" y="216568"/>
              <a:ext cx="300789" cy="439754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2088285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picture containing text, light, traffic, red&#10;&#10;Description automatically generated">
            <a:extLst>
              <a:ext uri="{FF2B5EF4-FFF2-40B4-BE49-F238E27FC236}">
                <a16:creationId xmlns:a16="http://schemas.microsoft.com/office/drawing/2014/main" id="{5D94660E-7663-4E1E-BD87-4903AD58B0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-163777"/>
            <a:ext cx="7772400" cy="1005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00496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A19792AF-FCCB-4B64-A054-BAB3CD1A60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38" y="156950"/>
            <a:ext cx="8147713" cy="106588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38343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ell phone&#10;&#10;Description automatically generated with medium confidence">
            <a:extLst>
              <a:ext uri="{FF2B5EF4-FFF2-40B4-BE49-F238E27FC236}">
                <a16:creationId xmlns:a16="http://schemas.microsoft.com/office/drawing/2014/main" id="{E232C585-5430-4D98-BB0E-9A794E947F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038" y="-264901"/>
            <a:ext cx="7698747" cy="99630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07106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F288DE53-A019-49D0-95FB-5DC0689BB95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436" y="-127392"/>
            <a:ext cx="8040757" cy="100654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3138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screenshot of a video game&#10;&#10;Description automatically generated with medium confidence">
            <a:extLst>
              <a:ext uri="{FF2B5EF4-FFF2-40B4-BE49-F238E27FC236}">
                <a16:creationId xmlns:a16="http://schemas.microsoft.com/office/drawing/2014/main" id="{7082B5F9-741B-4734-BF37-F3471A3E6DF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626" y="-74944"/>
            <a:ext cx="7441774" cy="9433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20441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>
            <a:extLst>
              <a:ext uri="{FF2B5EF4-FFF2-40B4-BE49-F238E27FC236}">
                <a16:creationId xmlns:a16="http://schemas.microsoft.com/office/drawing/2014/main" id="{C938CEE3-7C08-4A1E-BF96-E70B7ECB92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000" y="4436547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b="1"/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25EF946-23BB-42DB-B319-C7959DC6FB2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4043053"/>
              </p:ext>
            </p:extLst>
          </p:nvPr>
        </p:nvGraphicFramePr>
        <p:xfrm>
          <a:off x="204511" y="852364"/>
          <a:ext cx="7363378" cy="3997449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2653923">
                  <a:extLst>
                    <a:ext uri="{9D8B030D-6E8A-4147-A177-3AD203B41FA5}">
                      <a16:colId xmlns:a16="http://schemas.microsoft.com/office/drawing/2014/main" val="943973484"/>
                    </a:ext>
                  </a:extLst>
                </a:gridCol>
                <a:gridCol w="1618246">
                  <a:extLst>
                    <a:ext uri="{9D8B030D-6E8A-4147-A177-3AD203B41FA5}">
                      <a16:colId xmlns:a16="http://schemas.microsoft.com/office/drawing/2014/main" val="3142255722"/>
                    </a:ext>
                  </a:extLst>
                </a:gridCol>
                <a:gridCol w="1553516">
                  <a:extLst>
                    <a:ext uri="{9D8B030D-6E8A-4147-A177-3AD203B41FA5}">
                      <a16:colId xmlns:a16="http://schemas.microsoft.com/office/drawing/2014/main" val="14958886"/>
                    </a:ext>
                  </a:extLst>
                </a:gridCol>
                <a:gridCol w="1537693">
                  <a:extLst>
                    <a:ext uri="{9D8B030D-6E8A-4147-A177-3AD203B41FA5}">
                      <a16:colId xmlns:a16="http://schemas.microsoft.com/office/drawing/2014/main" val="3372902771"/>
                    </a:ext>
                  </a:extLst>
                </a:gridCol>
              </a:tblGrid>
              <a:tr h="84331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s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onent 1 (42.05%)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onent 2 (28.18%)</a:t>
                      </a:r>
                      <a:endParaRPr lang="en-US" sz="11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onent 3 (16.20%)</a:t>
                      </a:r>
                      <a:endParaRPr lang="en-US" sz="11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94914698"/>
                  </a:ext>
                </a:extLst>
              </a:tr>
              <a:tr h="45059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AP Ipsilateral Hippocampus</a:t>
                      </a:r>
                      <a:endParaRPr lang="en-US" sz="11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6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3766370"/>
                  </a:ext>
                </a:extLst>
              </a:tr>
              <a:tr h="45059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AP Contralateral Hippocampus</a:t>
                      </a:r>
                      <a:endParaRPr lang="en-US" sz="11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1</a:t>
                      </a:r>
                      <a:endParaRPr lang="en-US" sz="11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9178396"/>
                  </a:ext>
                </a:extLst>
              </a:tr>
              <a:tr h="45059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AP Ipsilateral Thalamus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2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1289819"/>
                  </a:ext>
                </a:extLst>
              </a:tr>
              <a:tr h="45059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BA1 Ipsilateral Thalamus</a:t>
                      </a:r>
                      <a:endParaRPr lang="en-US" sz="11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43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b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8757517"/>
                  </a:ext>
                </a:extLst>
              </a:tr>
              <a:tr h="45059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BA1 Contralateral Thalamus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2</a:t>
                      </a:r>
                      <a:endParaRPr lang="en-US" sz="11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3821296"/>
                  </a:ext>
                </a:extLst>
              </a:tr>
              <a:tr h="45059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ppocampal Spared Volume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b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7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963175"/>
                  </a:ext>
                </a:extLst>
              </a:tr>
              <a:tr h="45059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tex Spared Volume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b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12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2752740"/>
                  </a:ext>
                </a:extLst>
              </a:tr>
            </a:tbl>
          </a:graphicData>
        </a:graphic>
      </p:graphicFrame>
      <p:sp>
        <p:nvSpPr>
          <p:cNvPr id="7" name="Rectangle 2">
            <a:extLst>
              <a:ext uri="{FF2B5EF4-FFF2-40B4-BE49-F238E27FC236}">
                <a16:creationId xmlns:a16="http://schemas.microsoft.com/office/drawing/2014/main" id="{38D1EC65-96CF-4710-B811-A44A8C627A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000" y="4392613"/>
            <a:ext cx="77724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75727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diagram&#10;&#10;Description automatically generated">
            <a:extLst>
              <a:ext uri="{FF2B5EF4-FFF2-40B4-BE49-F238E27FC236}">
                <a16:creationId xmlns:a16="http://schemas.microsoft.com/office/drawing/2014/main" id="{7FFD76F5-F1B5-4EB3-BF4B-D07017DD202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204" b="33900"/>
          <a:stretch/>
        </p:blipFill>
        <p:spPr>
          <a:xfrm>
            <a:off x="-933368" y="-481867"/>
            <a:ext cx="8432814" cy="80145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15783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528</TotalTime>
  <Words>44</Words>
  <Application>Microsoft Office PowerPoint</Application>
  <PresentationFormat>Custom</PresentationFormat>
  <Paragraphs>18</Paragraphs>
  <Slides>10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antha Smith</dc:creator>
  <cp:lastModifiedBy>Samantha Smith</cp:lastModifiedBy>
  <cp:revision>74</cp:revision>
  <dcterms:created xsi:type="dcterms:W3CDTF">2021-10-12T23:38:03Z</dcterms:created>
  <dcterms:modified xsi:type="dcterms:W3CDTF">2022-04-05T16:57:02Z</dcterms:modified>
</cp:coreProperties>
</file>